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292" y="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804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4522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366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5407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1631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872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6943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1869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530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742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0101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7CC54-EE25-4296-9B69-983A6E46DF8F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E2CF07-F889-4DFB-9795-C51EAB62E7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77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60" name="直接箭头连接符 259">
            <a:extLst>
              <a:ext uri="{FF2B5EF4-FFF2-40B4-BE49-F238E27FC236}">
                <a16:creationId xmlns:a16="http://schemas.microsoft.com/office/drawing/2014/main" id="{34D0B794-B8FE-4C0E-A49B-530AD731FCAC}"/>
              </a:ext>
            </a:extLst>
          </p:cNvPr>
          <p:cNvCxnSpPr>
            <a:cxnSpLocks/>
          </p:cNvCxnSpPr>
          <p:nvPr/>
        </p:nvCxnSpPr>
        <p:spPr>
          <a:xfrm rot="21540000">
            <a:off x="8191695" y="11271002"/>
            <a:ext cx="0" cy="18092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3" name="组合 332">
            <a:extLst>
              <a:ext uri="{FF2B5EF4-FFF2-40B4-BE49-F238E27FC236}">
                <a16:creationId xmlns:a16="http://schemas.microsoft.com/office/drawing/2014/main" id="{FF1DED20-6BCA-4FBA-917F-FFBD0D134498}"/>
              </a:ext>
            </a:extLst>
          </p:cNvPr>
          <p:cNvGrpSpPr/>
          <p:nvPr/>
        </p:nvGrpSpPr>
        <p:grpSpPr>
          <a:xfrm>
            <a:off x="799103" y="1409620"/>
            <a:ext cx="4947153" cy="7434031"/>
            <a:chOff x="1594959" y="359870"/>
            <a:chExt cx="4947153" cy="7434031"/>
          </a:xfrm>
        </p:grpSpPr>
        <p:cxnSp>
          <p:nvCxnSpPr>
            <p:cNvPr id="140" name="直接箭头连接符 139">
              <a:extLst>
                <a:ext uri="{FF2B5EF4-FFF2-40B4-BE49-F238E27FC236}">
                  <a16:creationId xmlns:a16="http://schemas.microsoft.com/office/drawing/2014/main" id="{7C483B99-137F-474A-8A4A-4A89D4005873}"/>
                </a:ext>
              </a:extLst>
            </p:cNvPr>
            <p:cNvCxnSpPr>
              <a:cxnSpLocks/>
            </p:cNvCxnSpPr>
            <p:nvPr/>
          </p:nvCxnSpPr>
          <p:spPr>
            <a:xfrm rot="21540000">
              <a:off x="4765682" y="3789614"/>
              <a:ext cx="0" cy="1809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2" name="组合 331">
              <a:extLst>
                <a:ext uri="{FF2B5EF4-FFF2-40B4-BE49-F238E27FC236}">
                  <a16:creationId xmlns:a16="http://schemas.microsoft.com/office/drawing/2014/main" id="{BC4C6906-6785-422F-A2C2-2FB189BF8F68}"/>
                </a:ext>
              </a:extLst>
            </p:cNvPr>
            <p:cNvGrpSpPr/>
            <p:nvPr/>
          </p:nvGrpSpPr>
          <p:grpSpPr>
            <a:xfrm>
              <a:off x="1594959" y="359870"/>
              <a:ext cx="4947153" cy="7434031"/>
              <a:chOff x="1594959" y="359870"/>
              <a:chExt cx="4947153" cy="7434031"/>
            </a:xfrm>
          </p:grpSpPr>
          <p:grpSp>
            <p:nvGrpSpPr>
              <p:cNvPr id="331" name="组合 330">
                <a:extLst>
                  <a:ext uri="{FF2B5EF4-FFF2-40B4-BE49-F238E27FC236}">
                    <a16:creationId xmlns:a16="http://schemas.microsoft.com/office/drawing/2014/main" id="{BE34889D-DC73-4DE2-9547-77A8B88CA737}"/>
                  </a:ext>
                </a:extLst>
              </p:cNvPr>
              <p:cNvGrpSpPr/>
              <p:nvPr/>
            </p:nvGrpSpPr>
            <p:grpSpPr>
              <a:xfrm>
                <a:off x="1594959" y="359870"/>
                <a:ext cx="4947153" cy="7434031"/>
                <a:chOff x="1594959" y="359870"/>
                <a:chExt cx="4947153" cy="7434031"/>
              </a:xfrm>
            </p:grpSpPr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CBFB0129-19C8-4DAD-B230-BC1400979F81}"/>
                    </a:ext>
                  </a:extLst>
                </p:cNvPr>
                <p:cNvSpPr txBox="1"/>
                <p:nvPr/>
              </p:nvSpPr>
              <p:spPr>
                <a:xfrm>
                  <a:off x="4576950" y="3599879"/>
                  <a:ext cx="5062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PP</a:t>
                  </a:r>
                  <a:endParaRPr lang="zh-CN" alt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6" name="组合 35">
                  <a:extLst>
                    <a:ext uri="{FF2B5EF4-FFF2-40B4-BE49-F238E27FC236}">
                      <a16:creationId xmlns:a16="http://schemas.microsoft.com/office/drawing/2014/main" id="{8F6B6205-DF38-4952-B261-0FC245906501}"/>
                    </a:ext>
                  </a:extLst>
                </p:cNvPr>
                <p:cNvGrpSpPr/>
                <p:nvPr/>
              </p:nvGrpSpPr>
              <p:grpSpPr>
                <a:xfrm>
                  <a:off x="4545238" y="1456900"/>
                  <a:ext cx="856234" cy="407289"/>
                  <a:chOff x="4545238" y="1456900"/>
                  <a:chExt cx="856234" cy="407289"/>
                </a:xfrm>
              </p:grpSpPr>
              <p:sp>
                <p:nvSpPr>
                  <p:cNvPr id="9" name="文本框 8">
                    <a:extLst>
                      <a:ext uri="{FF2B5EF4-FFF2-40B4-BE49-F238E27FC236}">
                        <a16:creationId xmlns:a16="http://schemas.microsoft.com/office/drawing/2014/main" id="{3666B0F5-440A-4C10-9C8E-459C7C43E8E2}"/>
                      </a:ext>
                    </a:extLst>
                  </p:cNvPr>
                  <p:cNvSpPr txBox="1"/>
                  <p:nvPr/>
                </p:nvSpPr>
                <p:spPr>
                  <a:xfrm>
                    <a:off x="4545238" y="1456900"/>
                    <a:ext cx="56968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XP</a:t>
                    </a:r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矩形 28">
                    <a:extLst>
                      <a:ext uri="{FF2B5EF4-FFF2-40B4-BE49-F238E27FC236}">
                        <a16:creationId xmlns:a16="http://schemas.microsoft.com/office/drawing/2014/main" id="{02C19B5C-3E1A-4016-8ABE-1BD326628E6E}"/>
                      </a:ext>
                    </a:extLst>
                  </p:cNvPr>
                  <p:cNvSpPr/>
                  <p:nvPr/>
                </p:nvSpPr>
                <p:spPr>
                  <a:xfrm>
                    <a:off x="4997464" y="1700134"/>
                    <a:ext cx="404008" cy="164055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800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XR</a:t>
                    </a:r>
                    <a:endParaRPr lang="zh-CN" altLang="en-US" sz="800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13" name="直接箭头连接符 112">
                    <a:extLst>
                      <a:ext uri="{FF2B5EF4-FFF2-40B4-BE49-F238E27FC236}">
                        <a16:creationId xmlns:a16="http://schemas.microsoft.com/office/drawing/2014/main" id="{E116D6E6-7CB1-4BAD-858C-0A77568BAB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21540000">
                    <a:off x="4751709" y="1661965"/>
                    <a:ext cx="0" cy="18092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51" name="组合 150">
                  <a:extLst>
                    <a:ext uri="{FF2B5EF4-FFF2-40B4-BE49-F238E27FC236}">
                      <a16:creationId xmlns:a16="http://schemas.microsoft.com/office/drawing/2014/main" id="{3DC1E0CF-75EF-4742-80AB-AC01580D243A}"/>
                    </a:ext>
                  </a:extLst>
                </p:cNvPr>
                <p:cNvGrpSpPr/>
                <p:nvPr/>
              </p:nvGrpSpPr>
              <p:grpSpPr>
                <a:xfrm>
                  <a:off x="4564779" y="4155396"/>
                  <a:ext cx="831872" cy="545893"/>
                  <a:chOff x="4545238" y="1297000"/>
                  <a:chExt cx="831872" cy="545893"/>
                </a:xfrm>
              </p:grpSpPr>
              <p:sp>
                <p:nvSpPr>
                  <p:cNvPr id="152" name="文本框 151">
                    <a:extLst>
                      <a:ext uri="{FF2B5EF4-FFF2-40B4-BE49-F238E27FC236}">
                        <a16:creationId xmlns:a16="http://schemas.microsoft.com/office/drawing/2014/main" id="{97C2C22E-6789-4EDB-8EA8-DB0902528169}"/>
                      </a:ext>
                    </a:extLst>
                  </p:cNvPr>
                  <p:cNvSpPr txBox="1"/>
                  <p:nvPr/>
                </p:nvSpPr>
                <p:spPr>
                  <a:xfrm>
                    <a:off x="4545238" y="1456900"/>
                    <a:ext cx="56968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PP</a:t>
                    </a:r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3" name="矩形 152">
                    <a:extLst>
                      <a:ext uri="{FF2B5EF4-FFF2-40B4-BE49-F238E27FC236}">
                        <a16:creationId xmlns:a16="http://schemas.microsoft.com/office/drawing/2014/main" id="{0453F70F-D110-446A-A453-A5EA42198800}"/>
                      </a:ext>
                    </a:extLst>
                  </p:cNvPr>
                  <p:cNvSpPr/>
                  <p:nvPr/>
                </p:nvSpPr>
                <p:spPr>
                  <a:xfrm>
                    <a:off x="4973102" y="1297000"/>
                    <a:ext cx="404008" cy="164055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800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PS</a:t>
                    </a:r>
                    <a:endParaRPr lang="zh-CN" altLang="en-US" sz="800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54" name="直接箭头连接符 153">
                    <a:extLst>
                      <a:ext uri="{FF2B5EF4-FFF2-40B4-BE49-F238E27FC236}">
                        <a16:creationId xmlns:a16="http://schemas.microsoft.com/office/drawing/2014/main" id="{90101ABD-3326-4889-AA5C-0C4CA0126D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21540000">
                    <a:off x="4751709" y="1661965"/>
                    <a:ext cx="0" cy="18092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6" name="组合 225">
                  <a:extLst>
                    <a:ext uri="{FF2B5EF4-FFF2-40B4-BE49-F238E27FC236}">
                      <a16:creationId xmlns:a16="http://schemas.microsoft.com/office/drawing/2014/main" id="{40979CF9-670D-49A4-A69C-6A4CBBAAACB2}"/>
                    </a:ext>
                  </a:extLst>
                </p:cNvPr>
                <p:cNvGrpSpPr/>
                <p:nvPr/>
              </p:nvGrpSpPr>
              <p:grpSpPr>
                <a:xfrm>
                  <a:off x="4392505" y="5350649"/>
                  <a:ext cx="954802" cy="400425"/>
                  <a:chOff x="4396237" y="5436521"/>
                  <a:chExt cx="954802" cy="400425"/>
                </a:xfrm>
              </p:grpSpPr>
              <p:sp>
                <p:nvSpPr>
                  <p:cNvPr id="221" name="文本框 220">
                    <a:extLst>
                      <a:ext uri="{FF2B5EF4-FFF2-40B4-BE49-F238E27FC236}">
                        <a16:creationId xmlns:a16="http://schemas.microsoft.com/office/drawing/2014/main" id="{4DC896AA-8C28-4B31-AADF-929B8C918C93}"/>
                      </a:ext>
                    </a:extLst>
                  </p:cNvPr>
                  <p:cNvSpPr txBox="1"/>
                  <p:nvPr/>
                </p:nvSpPr>
                <p:spPr>
                  <a:xfrm>
                    <a:off x="4396237" y="5436521"/>
                    <a:ext cx="95480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zeaxanthin</a:t>
                    </a:r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222" name="组合 221">
                    <a:extLst>
                      <a:ext uri="{FF2B5EF4-FFF2-40B4-BE49-F238E27FC236}">
                        <a16:creationId xmlns:a16="http://schemas.microsoft.com/office/drawing/2014/main" id="{4C449620-29C1-439D-84A4-C2A10A267D04}"/>
                      </a:ext>
                    </a:extLst>
                  </p:cNvPr>
                  <p:cNvGrpSpPr/>
                  <p:nvPr/>
                </p:nvGrpSpPr>
                <p:grpSpPr>
                  <a:xfrm>
                    <a:off x="4772985" y="5651480"/>
                    <a:ext cx="574186" cy="185466"/>
                    <a:chOff x="4747899" y="1585037"/>
                    <a:chExt cx="574186" cy="185466"/>
                  </a:xfrm>
                </p:grpSpPr>
                <p:sp>
                  <p:nvSpPr>
                    <p:cNvPr id="224" name="矩形 223">
                      <a:extLst>
                        <a:ext uri="{FF2B5EF4-FFF2-40B4-BE49-F238E27FC236}">
                          <a16:creationId xmlns:a16="http://schemas.microsoft.com/office/drawing/2014/main" id="{C693393B-FBD9-4797-9D04-32072E1E2C7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954262" y="1585037"/>
                      <a:ext cx="367823" cy="150891"/>
                    </a:xfrm>
                    <a:prstGeom prst="rect">
                      <a:avLst/>
                    </a:prstGeom>
                    <a:noFill/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zh-CN" sz="700" b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EP</a:t>
                      </a:r>
                      <a:endParaRPr lang="zh-CN" altLang="en-US" sz="700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25" name="直接箭头连接符 224">
                      <a:extLst>
                        <a:ext uri="{FF2B5EF4-FFF2-40B4-BE49-F238E27FC236}">
                          <a16:creationId xmlns:a16="http://schemas.microsoft.com/office/drawing/2014/main" id="{2236D9CA-34E0-4EA3-ADD8-1F817D3196A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21540000">
                      <a:off x="4747899" y="1589575"/>
                      <a:ext cx="0" cy="180928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30" name="组合 329">
                  <a:extLst>
                    <a:ext uri="{FF2B5EF4-FFF2-40B4-BE49-F238E27FC236}">
                      <a16:creationId xmlns:a16="http://schemas.microsoft.com/office/drawing/2014/main" id="{1F507A3E-BD61-4C51-AECD-B60D71272EDD}"/>
                    </a:ext>
                  </a:extLst>
                </p:cNvPr>
                <p:cNvGrpSpPr/>
                <p:nvPr/>
              </p:nvGrpSpPr>
              <p:grpSpPr>
                <a:xfrm>
                  <a:off x="1594959" y="359870"/>
                  <a:ext cx="4947153" cy="7434031"/>
                  <a:chOff x="1594959" y="359870"/>
                  <a:chExt cx="4947153" cy="7434031"/>
                </a:xfrm>
              </p:grpSpPr>
              <p:sp>
                <p:nvSpPr>
                  <p:cNvPr id="5" name="文本框 4">
                    <a:extLst>
                      <a:ext uri="{FF2B5EF4-FFF2-40B4-BE49-F238E27FC236}">
                        <a16:creationId xmlns:a16="http://schemas.microsoft.com/office/drawing/2014/main" id="{548776E7-4603-41F3-BAAC-E84F3EDDB3CA}"/>
                      </a:ext>
                    </a:extLst>
                  </p:cNvPr>
                  <p:cNvSpPr txBox="1"/>
                  <p:nvPr/>
                </p:nvSpPr>
                <p:spPr>
                  <a:xfrm>
                    <a:off x="4235802" y="489787"/>
                    <a:ext cx="159657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P pathway</a:t>
                    </a:r>
                    <a:endParaRPr lang="zh-CN" altLang="en-US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" name="文本框 5">
                    <a:extLst>
                      <a:ext uri="{FF2B5EF4-FFF2-40B4-BE49-F238E27FC236}">
                        <a16:creationId xmlns:a16="http://schemas.microsoft.com/office/drawing/2014/main" id="{3D3ACF8A-5E5E-446D-AD89-9D3A8B079447}"/>
                      </a:ext>
                    </a:extLst>
                  </p:cNvPr>
                  <p:cNvSpPr txBox="1"/>
                  <p:nvPr/>
                </p:nvSpPr>
                <p:spPr>
                  <a:xfrm>
                    <a:off x="1802706" y="1041559"/>
                    <a:ext cx="159657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VA pathway</a:t>
                    </a:r>
                    <a:endParaRPr lang="zh-CN" altLang="en-US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321" name="组合 320">
                    <a:extLst>
                      <a:ext uri="{FF2B5EF4-FFF2-40B4-BE49-F238E27FC236}">
                        <a16:creationId xmlns:a16="http://schemas.microsoft.com/office/drawing/2014/main" id="{710A7545-2266-41A5-8AE8-AA99027A1E4F}"/>
                      </a:ext>
                    </a:extLst>
                  </p:cNvPr>
                  <p:cNvGrpSpPr/>
                  <p:nvPr/>
                </p:nvGrpSpPr>
                <p:grpSpPr>
                  <a:xfrm>
                    <a:off x="1594959" y="359870"/>
                    <a:ext cx="4947153" cy="7434031"/>
                    <a:chOff x="1594959" y="359870"/>
                    <a:chExt cx="4947153" cy="7434031"/>
                  </a:xfrm>
                </p:grpSpPr>
                <p:cxnSp>
                  <p:nvCxnSpPr>
                    <p:cNvPr id="93" name="直接箭头连接符 92">
                      <a:extLst>
                        <a:ext uri="{FF2B5EF4-FFF2-40B4-BE49-F238E27FC236}">
                          <a16:creationId xmlns:a16="http://schemas.microsoft.com/office/drawing/2014/main" id="{8CF27288-E0C2-4B3F-BD74-1420F381545D}"/>
                        </a:ext>
                      </a:extLst>
                    </p:cNvPr>
                    <p:cNvCxnSpPr>
                      <a:cxnSpLocks/>
                      <a:stCxn id="159" idx="3"/>
                      <a:endCxn id="62" idx="1"/>
                    </p:cNvCxnSpPr>
                    <p:nvPr/>
                  </p:nvCxnSpPr>
                  <p:spPr>
                    <a:xfrm>
                      <a:off x="2611231" y="3720530"/>
                      <a:ext cx="1965719" cy="2460"/>
                    </a:xfrm>
                    <a:prstGeom prst="straightConnector1">
                      <a:avLst/>
                    </a:prstGeom>
                    <a:ln w="19050">
                      <a:headEnd type="triangle"/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12" name="组合 211">
                      <a:extLst>
                        <a:ext uri="{FF2B5EF4-FFF2-40B4-BE49-F238E27FC236}">
                          <a16:creationId xmlns:a16="http://schemas.microsoft.com/office/drawing/2014/main" id="{23F67BAB-7BDA-4C6C-A6A7-0D3CD49A345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94959" y="1443056"/>
                      <a:ext cx="1663036" cy="2400584"/>
                      <a:chOff x="2397237" y="1446658"/>
                      <a:chExt cx="1663036" cy="2400584"/>
                    </a:xfrm>
                  </p:grpSpPr>
                  <p:grpSp>
                    <p:nvGrpSpPr>
                      <p:cNvPr id="42" name="组合 41">
                        <a:extLst>
                          <a:ext uri="{FF2B5EF4-FFF2-40B4-BE49-F238E27FC236}">
                            <a16:creationId xmlns:a16="http://schemas.microsoft.com/office/drawing/2014/main" id="{F6A89B30-A54C-47DA-B089-8C027BEC873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97237" y="1833072"/>
                        <a:ext cx="1663036" cy="2014170"/>
                        <a:chOff x="2842942" y="1865908"/>
                        <a:chExt cx="1663036" cy="2014170"/>
                      </a:xfrm>
                    </p:grpSpPr>
                    <p:grpSp>
                      <p:nvGrpSpPr>
                        <p:cNvPr id="168" name="组合 167">
                          <a:extLst>
                            <a:ext uri="{FF2B5EF4-FFF2-40B4-BE49-F238E27FC236}">
                              <a16:creationId xmlns:a16="http://schemas.microsoft.com/office/drawing/2014/main" id="{5C361F91-E327-4E13-892D-59709644B5D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09774" y="2625817"/>
                          <a:ext cx="978834" cy="385993"/>
                          <a:chOff x="4136090" y="1456900"/>
                          <a:chExt cx="978834" cy="385993"/>
                        </a:xfrm>
                      </p:grpSpPr>
                      <p:sp>
                        <p:nvSpPr>
                          <p:cNvPr id="169" name="文本框 168">
                            <a:extLst>
                              <a:ext uri="{FF2B5EF4-FFF2-40B4-BE49-F238E27FC236}">
                                <a16:creationId xmlns:a16="http://schemas.microsoft.com/office/drawing/2014/main" id="{C643EEE3-730F-4A91-8608-00E7D54D8D7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545238" y="1456900"/>
                            <a:ext cx="569686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altLang="zh-CN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MVA</a:t>
                            </a:r>
                            <a:endParaRPr lang="zh-CN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70" name="矩形 169">
                            <a:extLst>
                              <a:ext uri="{FF2B5EF4-FFF2-40B4-BE49-F238E27FC236}">
                                <a16:creationId xmlns:a16="http://schemas.microsoft.com/office/drawing/2014/main" id="{0A2AE2B2-1DB4-4AFE-8F54-F36AA602EBD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136090" y="1672386"/>
                            <a:ext cx="404008" cy="154624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800" b="1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MK</a:t>
                            </a:r>
                            <a:endParaRPr lang="zh-CN" altLang="en-US" sz="800" b="1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cxnSp>
                        <p:nvCxnSpPr>
                          <p:cNvPr id="171" name="直接箭头连接符 170">
                            <a:extLst>
                              <a:ext uri="{FF2B5EF4-FFF2-40B4-BE49-F238E27FC236}">
                                <a16:creationId xmlns:a16="http://schemas.microsoft.com/office/drawing/2014/main" id="{71A11962-913C-47FE-BE26-6F83F9B82E5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1540000">
                            <a:off x="4751709" y="1661965"/>
                            <a:ext cx="0" cy="180928"/>
                          </a:xfrm>
                          <a:prstGeom prst="straightConnector1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41" name="组合 40">
                          <a:extLst>
                            <a:ext uri="{FF2B5EF4-FFF2-40B4-BE49-F238E27FC236}">
                              <a16:creationId xmlns:a16="http://schemas.microsoft.com/office/drawing/2014/main" id="{98674C25-C483-4E12-BE27-4951EF71C81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842942" y="1865908"/>
                          <a:ext cx="1663036" cy="2014170"/>
                          <a:chOff x="2842942" y="1865908"/>
                          <a:chExt cx="1663036" cy="2014170"/>
                        </a:xfrm>
                      </p:grpSpPr>
                      <p:grpSp>
                        <p:nvGrpSpPr>
                          <p:cNvPr id="40" name="组合 39">
                            <a:extLst>
                              <a:ext uri="{FF2B5EF4-FFF2-40B4-BE49-F238E27FC236}">
                                <a16:creationId xmlns:a16="http://schemas.microsoft.com/office/drawing/2014/main" id="{C60EA5ED-5590-4FC6-A191-8E5D41970229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916450" y="2967807"/>
                            <a:ext cx="1022558" cy="912271"/>
                            <a:chOff x="2916450" y="2967807"/>
                            <a:chExt cx="1022558" cy="912271"/>
                          </a:xfrm>
                        </p:grpSpPr>
                        <p:sp>
                          <p:nvSpPr>
                            <p:cNvPr id="159" name="文本框 158">
                              <a:extLst>
                                <a:ext uri="{FF2B5EF4-FFF2-40B4-BE49-F238E27FC236}">
                                  <a16:creationId xmlns:a16="http://schemas.microsoft.com/office/drawing/2014/main" id="{6D453259-00D6-49A5-A38C-6953933AB68F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352952" y="3633857"/>
                              <a:ext cx="50626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 b="1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PP</a:t>
                              </a:r>
                              <a:endParaRPr lang="zh-CN" altLang="en-US" sz="1000" b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38" name="组合 37">
                              <a:extLst>
                                <a:ext uri="{FF2B5EF4-FFF2-40B4-BE49-F238E27FC236}">
                                  <a16:creationId xmlns:a16="http://schemas.microsoft.com/office/drawing/2014/main" id="{37DADCE0-889D-48DB-BFDA-4A439F852C28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2916450" y="2967807"/>
                              <a:ext cx="1022558" cy="726410"/>
                              <a:chOff x="2916450" y="2967807"/>
                              <a:chExt cx="1022558" cy="726410"/>
                            </a:xfrm>
                          </p:grpSpPr>
                          <p:grpSp>
                            <p:nvGrpSpPr>
                              <p:cNvPr id="160" name="组合 159">
                                <a:extLst>
                                  <a:ext uri="{FF2B5EF4-FFF2-40B4-BE49-F238E27FC236}">
                                    <a16:creationId xmlns:a16="http://schemas.microsoft.com/office/drawing/2014/main" id="{82F8D434-4201-4E1A-8F4D-C980A9C4AF7D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2916450" y="3302619"/>
                                <a:ext cx="977394" cy="391598"/>
                                <a:chOff x="4137530" y="1456900"/>
                                <a:chExt cx="977394" cy="391598"/>
                              </a:xfrm>
                            </p:grpSpPr>
                            <p:sp>
                              <p:nvSpPr>
                                <p:cNvPr id="161" name="文本框 160">
                                  <a:extLst>
                                    <a:ext uri="{FF2B5EF4-FFF2-40B4-BE49-F238E27FC236}">
                                      <a16:creationId xmlns:a16="http://schemas.microsoft.com/office/drawing/2014/main" id="{5D1A87A7-CC92-4545-A62A-5C3D36C3705D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469655" y="1456900"/>
                                  <a:ext cx="64526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10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VAPP</a:t>
                                  </a:r>
                                  <a:endParaRPr lang="zh-CN" altLang="en-US" sz="10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162" name="矩形 161">
                                  <a:extLst>
                                    <a:ext uri="{FF2B5EF4-FFF2-40B4-BE49-F238E27FC236}">
                                      <a16:creationId xmlns:a16="http://schemas.microsoft.com/office/drawing/2014/main" id="{9D9FCF93-D808-4A9B-8742-B81C16B76B04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4137530" y="1684443"/>
                                  <a:ext cx="404008" cy="164055"/>
                                </a:xfrm>
                                <a:prstGeom prst="rect">
                                  <a:avLst/>
                                </a:prstGeom>
                                <a:noFill/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altLang="zh-CN" sz="700" b="1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DC</a:t>
                                  </a:r>
                                  <a:endParaRPr lang="zh-CN" altLang="en-US" sz="700" b="1">
                                    <a:solidFill>
                                      <a:schemeClr val="tx1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cxnSp>
                              <p:nvCxnSpPr>
                                <p:cNvPr id="163" name="直接箭头连接符 162">
                                  <a:extLst>
                                    <a:ext uri="{FF2B5EF4-FFF2-40B4-BE49-F238E27FC236}">
                                      <a16:creationId xmlns:a16="http://schemas.microsoft.com/office/drawing/2014/main" id="{0220F4CF-2700-4413-9971-F601B51B7D7A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21540000">
                                  <a:off x="4751709" y="1661965"/>
                                  <a:ext cx="0" cy="180928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grpSp>
                            <p:nvGrpSpPr>
                              <p:cNvPr id="164" name="组合 163">
                                <a:extLst>
                                  <a:ext uri="{FF2B5EF4-FFF2-40B4-BE49-F238E27FC236}">
                                    <a16:creationId xmlns:a16="http://schemas.microsoft.com/office/drawing/2014/main" id="{20897898-AC43-4451-92AA-EB01EE97F6AC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3293739" y="2967807"/>
                                <a:ext cx="645269" cy="378343"/>
                                <a:chOff x="4515246" y="1464550"/>
                                <a:chExt cx="645269" cy="378343"/>
                              </a:xfrm>
                            </p:grpSpPr>
                            <p:sp>
                              <p:nvSpPr>
                                <p:cNvPr id="165" name="文本框 164">
                                  <a:extLst>
                                    <a:ext uri="{FF2B5EF4-FFF2-40B4-BE49-F238E27FC236}">
                                      <a16:creationId xmlns:a16="http://schemas.microsoft.com/office/drawing/2014/main" id="{9CD26742-61C9-491B-9EF6-1A94DCA95A60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515246" y="1464550"/>
                                  <a:ext cx="645269" cy="230832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9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VAP</a:t>
                                  </a:r>
                                  <a:endParaRPr lang="zh-CN" altLang="en-US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cxnSp>
                              <p:nvCxnSpPr>
                                <p:cNvPr id="166" name="直接箭头连接符 165">
                                  <a:extLst>
                                    <a:ext uri="{FF2B5EF4-FFF2-40B4-BE49-F238E27FC236}">
                                      <a16:creationId xmlns:a16="http://schemas.microsoft.com/office/drawing/2014/main" id="{BDFA5C52-DE1A-4493-B12E-1A738DD76708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21540000">
                                  <a:off x="4751709" y="1661965"/>
                                  <a:ext cx="0" cy="180928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sp>
                            <p:nvSpPr>
                              <p:cNvPr id="167" name="矩形 166">
                                <a:extLst>
                                  <a:ext uri="{FF2B5EF4-FFF2-40B4-BE49-F238E27FC236}">
                                    <a16:creationId xmlns:a16="http://schemas.microsoft.com/office/drawing/2014/main" id="{168E9AE9-8502-45F0-ADFF-A91DFE2CD757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916450" y="3166381"/>
                                <a:ext cx="404008" cy="164055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altLang="zh-CN" sz="700" b="1">
                                    <a:solidFill>
                                      <a:schemeClr val="tx1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PMK</a:t>
                                </a:r>
                                <a:endParaRPr lang="zh-CN" altLang="en-US" sz="700" b="1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</p:grpSp>
                      </p:grpSp>
                      <p:grpSp>
                        <p:nvGrpSpPr>
                          <p:cNvPr id="172" name="组合 171">
                            <a:extLst>
                              <a:ext uri="{FF2B5EF4-FFF2-40B4-BE49-F238E27FC236}">
                                <a16:creationId xmlns:a16="http://schemas.microsoft.com/office/drawing/2014/main" id="{75E9D651-754A-4166-9819-B2DEF1C40C59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842942" y="2248208"/>
                            <a:ext cx="1187390" cy="431189"/>
                            <a:chOff x="4067722" y="1420318"/>
                            <a:chExt cx="1187390" cy="431189"/>
                          </a:xfrm>
                        </p:grpSpPr>
                        <p:sp>
                          <p:nvSpPr>
                            <p:cNvPr id="173" name="文本框 172">
                              <a:extLst>
                                <a:ext uri="{FF2B5EF4-FFF2-40B4-BE49-F238E27FC236}">
                                  <a16:creationId xmlns:a16="http://schemas.microsoft.com/office/drawing/2014/main" id="{C7201D32-45FF-4A35-B55A-CB1466D39B3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409873" y="1420318"/>
                              <a:ext cx="845239" cy="40011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HMG-CoA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  <a:p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74" name="矩形 173">
                              <a:extLst>
                                <a:ext uri="{FF2B5EF4-FFF2-40B4-BE49-F238E27FC236}">
                                  <a16:creationId xmlns:a16="http://schemas.microsoft.com/office/drawing/2014/main" id="{2F5D6705-358F-475E-A171-E9824877C25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067722" y="1670605"/>
                              <a:ext cx="510010" cy="180902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800" b="1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HMGR</a:t>
                              </a:r>
                              <a:endParaRPr lang="zh-CN" altLang="en-US" sz="800" b="1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175" name="直接箭头连接符 174">
                              <a:extLst>
                                <a:ext uri="{FF2B5EF4-FFF2-40B4-BE49-F238E27FC236}">
                                  <a16:creationId xmlns:a16="http://schemas.microsoft.com/office/drawing/2014/main" id="{873C13C4-BFE5-443C-BB6A-43EA6E2FD9BD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rot="21540000">
                              <a:off x="4751709" y="1661965"/>
                              <a:ext cx="0" cy="180928"/>
                            </a:xfrm>
                            <a:prstGeom prst="straightConnector1">
                              <a:avLst/>
                            </a:prstGeom>
                            <a:ln w="19050">
                              <a:solidFill>
                                <a:schemeClr val="tx1"/>
                              </a:solidFill>
                              <a:tailEnd type="triangle"/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grpSp>
                        <p:nvGrpSpPr>
                          <p:cNvPr id="176" name="组合 175">
                            <a:extLst>
                              <a:ext uri="{FF2B5EF4-FFF2-40B4-BE49-F238E27FC236}">
                                <a16:creationId xmlns:a16="http://schemas.microsoft.com/office/drawing/2014/main" id="{0FAAB730-B996-4F82-AEE3-AAF004106698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538372" y="2417869"/>
                            <a:ext cx="967606" cy="246221"/>
                            <a:chOff x="3359160" y="2336501"/>
                            <a:chExt cx="967606" cy="246221"/>
                          </a:xfrm>
                        </p:grpSpPr>
                        <p:sp>
                          <p:nvSpPr>
                            <p:cNvPr id="177" name="文本框 176">
                              <a:extLst>
                                <a:ext uri="{FF2B5EF4-FFF2-40B4-BE49-F238E27FC236}">
                                  <a16:creationId xmlns:a16="http://schemas.microsoft.com/office/drawing/2014/main" id="{4CA371D1-B7D3-42F6-9CE7-A83177CF1D03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359160" y="2364244"/>
                              <a:ext cx="368551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>
                              <a:spAutoFit/>
                            </a:bodyPr>
                            <a:lstStyle/>
                            <a:p>
                              <a:r>
                                <a:rPr lang="zh-CN" altLang="en-US" sz="8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❌</a:t>
                              </a:r>
                            </a:p>
                          </p:txBody>
                        </p:sp>
                        <p:sp>
                          <p:nvSpPr>
                            <p:cNvPr id="178" name="文本框 177">
                              <a:extLst>
                                <a:ext uri="{FF2B5EF4-FFF2-40B4-BE49-F238E27FC236}">
                                  <a16:creationId xmlns:a16="http://schemas.microsoft.com/office/drawing/2014/main" id="{26E09061-3D9A-44B5-91A6-24BF2819733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551520" y="2336501"/>
                              <a:ext cx="775246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Mevinolin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  <p:grpSp>
                        <p:nvGrpSpPr>
                          <p:cNvPr id="179" name="组合 178">
                            <a:extLst>
                              <a:ext uri="{FF2B5EF4-FFF2-40B4-BE49-F238E27FC236}">
                                <a16:creationId xmlns:a16="http://schemas.microsoft.com/office/drawing/2014/main" id="{B745EB20-DFCF-4526-A0AA-E90E1E56F0E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842942" y="1865908"/>
                            <a:ext cx="1313767" cy="439601"/>
                            <a:chOff x="4067722" y="1420242"/>
                            <a:chExt cx="1313767" cy="439601"/>
                          </a:xfrm>
                        </p:grpSpPr>
                        <p:sp>
                          <p:nvSpPr>
                            <p:cNvPr id="180" name="文本框 179">
                              <a:extLst>
                                <a:ext uri="{FF2B5EF4-FFF2-40B4-BE49-F238E27FC236}">
                                  <a16:creationId xmlns:a16="http://schemas.microsoft.com/office/drawing/2014/main" id="{E4CCAC24-9E1A-4221-AB9F-29E91EA9A6A6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536250" y="1420242"/>
                              <a:ext cx="845239" cy="40011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ACC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  <a:p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81" name="矩形 180">
                              <a:extLst>
                                <a:ext uri="{FF2B5EF4-FFF2-40B4-BE49-F238E27FC236}">
                                  <a16:creationId xmlns:a16="http://schemas.microsoft.com/office/drawing/2014/main" id="{80ED4456-8CB3-46FC-9221-BAE4F91E978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067722" y="1670604"/>
                              <a:ext cx="510010" cy="189239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800" b="1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HMGS</a:t>
                              </a:r>
                              <a:endParaRPr lang="zh-CN" altLang="en-US" sz="800" b="1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182" name="直接箭头连接符 181">
                              <a:extLst>
                                <a:ext uri="{FF2B5EF4-FFF2-40B4-BE49-F238E27FC236}">
                                  <a16:creationId xmlns:a16="http://schemas.microsoft.com/office/drawing/2014/main" id="{49D717DD-7D2B-4A04-B85A-BE8591877E63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rot="21540000">
                              <a:off x="4751709" y="1661965"/>
                              <a:ext cx="0" cy="180928"/>
                            </a:xfrm>
                            <a:prstGeom prst="straightConnector1">
                              <a:avLst/>
                            </a:prstGeom>
                            <a:ln w="19050">
                              <a:solidFill>
                                <a:schemeClr val="tx1"/>
                              </a:solidFill>
                              <a:tailEnd type="triangle"/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</p:grpSp>
                  </p:grpSp>
                  <p:grpSp>
                    <p:nvGrpSpPr>
                      <p:cNvPr id="201" name="组合 200">
                        <a:extLst>
                          <a:ext uri="{FF2B5EF4-FFF2-40B4-BE49-F238E27FC236}">
                            <a16:creationId xmlns:a16="http://schemas.microsoft.com/office/drawing/2014/main" id="{EB4E21F7-DF24-4D89-84FF-825CFE295BE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413328" y="1446658"/>
                        <a:ext cx="1187390" cy="435689"/>
                        <a:chOff x="4067722" y="1420318"/>
                        <a:chExt cx="1187390" cy="435689"/>
                      </a:xfrm>
                    </p:grpSpPr>
                    <p:sp>
                      <p:nvSpPr>
                        <p:cNvPr id="202" name="文本框 201">
                          <a:extLst>
                            <a:ext uri="{FF2B5EF4-FFF2-40B4-BE49-F238E27FC236}">
                              <a16:creationId xmlns:a16="http://schemas.microsoft.com/office/drawing/2014/main" id="{DE3561C0-9A66-4397-AAC9-5F8BCDFB145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409873" y="1420318"/>
                          <a:ext cx="845239" cy="4001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altLang="zh-CN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cetyl-CoA</a:t>
                          </a:r>
                          <a:endParaRPr lang="zh-CN" altLang="en-US" sz="100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endParaRPr lang="zh-CN" altLang="en-US" sz="100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03" name="矩形 202">
                          <a:extLst>
                            <a:ext uri="{FF2B5EF4-FFF2-40B4-BE49-F238E27FC236}">
                              <a16:creationId xmlns:a16="http://schemas.microsoft.com/office/drawing/2014/main" id="{ECCD0A00-F49E-4CEF-A9BA-A489E089856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067722" y="1670604"/>
                          <a:ext cx="510010" cy="185403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altLang="zh-CN" sz="800" b="1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ACT</a:t>
                          </a:r>
                          <a:endParaRPr lang="zh-CN" altLang="en-US" sz="800" b="1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cxnSp>
                      <p:nvCxnSpPr>
                        <p:cNvPr id="204" name="直接箭头连接符 203">
                          <a:extLst>
                            <a:ext uri="{FF2B5EF4-FFF2-40B4-BE49-F238E27FC236}">
                              <a16:creationId xmlns:a16="http://schemas.microsoft.com/office/drawing/2014/main" id="{9AAF9A0E-F519-4EC7-880C-A7A8EB47590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1540000">
                          <a:off x="4751709" y="1661965"/>
                          <a:ext cx="0" cy="180928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320" name="组合 319">
                      <a:extLst>
                        <a:ext uri="{FF2B5EF4-FFF2-40B4-BE49-F238E27FC236}">
                          <a16:creationId xmlns:a16="http://schemas.microsoft.com/office/drawing/2014/main" id="{C4095AF1-A1E1-49DA-BF48-957957CEB93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78827" y="359870"/>
                      <a:ext cx="3363285" cy="7434031"/>
                      <a:chOff x="3178827" y="359870"/>
                      <a:chExt cx="3363285" cy="7434031"/>
                    </a:xfrm>
                  </p:grpSpPr>
                  <p:grpSp>
                    <p:nvGrpSpPr>
                      <p:cNvPr id="319" name="组合 318">
                        <a:extLst>
                          <a:ext uri="{FF2B5EF4-FFF2-40B4-BE49-F238E27FC236}">
                            <a16:creationId xmlns:a16="http://schemas.microsoft.com/office/drawing/2014/main" id="{A05B6DF6-81BB-4A58-A9B2-41BFA38DA9E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261307" y="924655"/>
                        <a:ext cx="3280805" cy="6869246"/>
                        <a:chOff x="3261307" y="924655"/>
                        <a:chExt cx="3280805" cy="6869246"/>
                      </a:xfrm>
                    </p:grpSpPr>
                    <p:grpSp>
                      <p:nvGrpSpPr>
                        <p:cNvPr id="301" name="组合 300">
                          <a:extLst>
                            <a:ext uri="{FF2B5EF4-FFF2-40B4-BE49-F238E27FC236}">
                              <a16:creationId xmlns:a16="http://schemas.microsoft.com/office/drawing/2014/main" id="{B31F97FC-B1E3-4D00-8A2D-DBDEC6B252C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691969" y="924655"/>
                          <a:ext cx="2096040" cy="645169"/>
                          <a:chOff x="3691969" y="924655"/>
                          <a:chExt cx="2096040" cy="645169"/>
                        </a:xfrm>
                      </p:grpSpPr>
                      <p:sp>
                        <p:nvSpPr>
                          <p:cNvPr id="7" name="文本框 6">
                            <a:extLst>
                              <a:ext uri="{FF2B5EF4-FFF2-40B4-BE49-F238E27FC236}">
                                <a16:creationId xmlns:a16="http://schemas.microsoft.com/office/drawing/2014/main" id="{F808B1BF-72D0-4434-A3A7-0365E331DD0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843095" y="939952"/>
                            <a:ext cx="834571" cy="26161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altLang="zh-CN" sz="105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GA-3P</a:t>
                            </a:r>
                            <a:endParaRPr lang="zh-CN" altLang="en-US" sz="105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8" name="文本框 7">
                            <a:extLst>
                              <a:ext uri="{FF2B5EF4-FFF2-40B4-BE49-F238E27FC236}">
                                <a16:creationId xmlns:a16="http://schemas.microsoft.com/office/drawing/2014/main" id="{29BEA9B2-8239-4703-8455-C8D5DE46994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739351" y="924655"/>
                            <a:ext cx="1048658" cy="25391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zh-CN" sz="105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Pyruvate</a:t>
                            </a:r>
                            <a:endParaRPr lang="zh-CN" altLang="en-US" sz="105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cxnSp>
                        <p:nvCxnSpPr>
                          <p:cNvPr id="13" name="连接符: 肘形 12">
                            <a:extLst>
                              <a:ext uri="{FF2B5EF4-FFF2-40B4-BE49-F238E27FC236}">
                                <a16:creationId xmlns:a16="http://schemas.microsoft.com/office/drawing/2014/main" id="{2971630D-9483-4A54-9655-A04A9D55647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5400000" flipH="1" flipV="1">
                            <a:off x="4702410" y="687139"/>
                            <a:ext cx="15297" cy="1003299"/>
                          </a:xfrm>
                          <a:prstGeom prst="bentConnector3">
                            <a:avLst>
                              <a:gd name="adj1" fmla="val -766693"/>
                            </a:avLst>
                          </a:prstGeom>
                          <a:ln w="19050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grpSp>
                        <p:nvGrpSpPr>
                          <p:cNvPr id="39" name="组合 38">
                            <a:extLst>
                              <a:ext uri="{FF2B5EF4-FFF2-40B4-BE49-F238E27FC236}">
                                <a16:creationId xmlns:a16="http://schemas.microsoft.com/office/drawing/2014/main" id="{3B71A709-531E-4F2C-940B-C2168D9C1582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691969" y="1323603"/>
                            <a:ext cx="1038304" cy="246221"/>
                            <a:chOff x="3680646" y="2314051"/>
                            <a:chExt cx="1038304" cy="246221"/>
                          </a:xfrm>
                        </p:grpSpPr>
                        <p:sp>
                          <p:nvSpPr>
                            <p:cNvPr id="24" name="文本框 23">
                              <a:extLst>
                                <a:ext uri="{FF2B5EF4-FFF2-40B4-BE49-F238E27FC236}">
                                  <a16:creationId xmlns:a16="http://schemas.microsoft.com/office/drawing/2014/main" id="{E0EA2761-D6BD-4D77-8945-D8519D90DD97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50399" y="2331758"/>
                              <a:ext cx="368551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>
                              <a:spAutoFit/>
                            </a:bodyPr>
                            <a:lstStyle/>
                            <a:p>
                              <a:r>
                                <a:rPr lang="zh-CN" altLang="en-US" sz="8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❌</a:t>
                              </a:r>
                            </a:p>
                          </p:txBody>
                        </p:sp>
                        <p:sp>
                          <p:nvSpPr>
                            <p:cNvPr id="25" name="文本框 24">
                              <a:extLst>
                                <a:ext uri="{FF2B5EF4-FFF2-40B4-BE49-F238E27FC236}">
                                  <a16:creationId xmlns:a16="http://schemas.microsoft.com/office/drawing/2014/main" id="{C21C9F91-E9DD-4036-BACD-22397875853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680646" y="2314051"/>
                              <a:ext cx="775246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Clomazone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26" name="直接箭头连接符 25">
                            <a:extLst>
                              <a:ext uri="{FF2B5EF4-FFF2-40B4-BE49-F238E27FC236}">
                                <a16:creationId xmlns:a16="http://schemas.microsoft.com/office/drawing/2014/main" id="{2E7BB527-9CD3-4FAD-B4D8-C5D8A8D316E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-60000">
                            <a:off x="4742427" y="1310790"/>
                            <a:ext cx="0" cy="180928"/>
                          </a:xfrm>
                          <a:prstGeom prst="straightConnector1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27" name="矩形 26">
                            <a:extLst>
                              <a:ext uri="{FF2B5EF4-FFF2-40B4-BE49-F238E27FC236}">
                                <a16:creationId xmlns:a16="http://schemas.microsoft.com/office/drawing/2014/main" id="{5F9C28BE-5C1D-4AD4-A014-A6354503F48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5003090" y="1391742"/>
                            <a:ext cx="413482" cy="164386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900" b="1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DXS</a:t>
                            </a:r>
                            <a:endParaRPr lang="zh-CN" altLang="en-US" sz="1000" b="1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303" name="组合 302">
                          <a:extLst>
                            <a:ext uri="{FF2B5EF4-FFF2-40B4-BE49-F238E27FC236}">
                              <a16:creationId xmlns:a16="http://schemas.microsoft.com/office/drawing/2014/main" id="{BDD614A6-9587-46D3-9DA9-7DB2992FDF1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453099" y="1840455"/>
                          <a:ext cx="1072458" cy="1796993"/>
                          <a:chOff x="4453099" y="1840455"/>
                          <a:chExt cx="1072458" cy="1796993"/>
                        </a:xfrm>
                      </p:grpSpPr>
                      <p:grpSp>
                        <p:nvGrpSpPr>
                          <p:cNvPr id="302" name="组合 301">
                            <a:extLst>
                              <a:ext uri="{FF2B5EF4-FFF2-40B4-BE49-F238E27FC236}">
                                <a16:creationId xmlns:a16="http://schemas.microsoft.com/office/drawing/2014/main" id="{B7F21AB9-2AC2-49CB-8A3A-9BB462F73B3C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453099" y="1840455"/>
                            <a:ext cx="1072458" cy="1796993"/>
                            <a:chOff x="4453099" y="1840455"/>
                            <a:chExt cx="1072458" cy="1796993"/>
                          </a:xfrm>
                        </p:grpSpPr>
                        <p:grpSp>
                          <p:nvGrpSpPr>
                            <p:cNvPr id="115" name="组合 114">
                              <a:extLst>
                                <a:ext uri="{FF2B5EF4-FFF2-40B4-BE49-F238E27FC236}">
                                  <a16:creationId xmlns:a16="http://schemas.microsoft.com/office/drawing/2014/main" id="{A6C8D89C-4064-435F-91DF-1680C10C1A03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554416" y="1840455"/>
                              <a:ext cx="847056" cy="385993"/>
                              <a:chOff x="4545238" y="1456900"/>
                              <a:chExt cx="847056" cy="385993"/>
                            </a:xfrm>
                          </p:grpSpPr>
                          <p:sp>
                            <p:nvSpPr>
                              <p:cNvPr id="118" name="文本框 117">
                                <a:extLst>
                                  <a:ext uri="{FF2B5EF4-FFF2-40B4-BE49-F238E27FC236}">
                                    <a16:creationId xmlns:a16="http://schemas.microsoft.com/office/drawing/2014/main" id="{4DC53387-2596-41FC-B030-1477E35D6A70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545238" y="1456900"/>
                                <a:ext cx="569686" cy="246221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10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MEP</a:t>
                                </a:r>
                                <a:endParaRPr lang="zh-CN" altLang="en-US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19" name="矩形 118">
                                <a:extLst>
                                  <a:ext uri="{FF2B5EF4-FFF2-40B4-BE49-F238E27FC236}">
                                    <a16:creationId xmlns:a16="http://schemas.microsoft.com/office/drawing/2014/main" id="{D48E42F6-495C-45BB-9C3C-0E0EB5FA2222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4988286" y="1640063"/>
                                <a:ext cx="404008" cy="164055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solidFill>
                                  <a:srgbClr val="FF0000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altLang="zh-CN" sz="700" b="1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MCT</a:t>
                                </a:r>
                                <a:endParaRPr lang="zh-CN" altLang="en-US" sz="7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20" name="直接箭头连接符 119">
                                <a:extLst>
                                  <a:ext uri="{FF2B5EF4-FFF2-40B4-BE49-F238E27FC236}">
                                    <a16:creationId xmlns:a16="http://schemas.microsoft.com/office/drawing/2014/main" id="{68BFBFD8-C81E-4196-A52E-122F3F46EA30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21540000">
                                <a:off x="4751709" y="1661965"/>
                                <a:ext cx="0" cy="180928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121" name="组合 120">
                              <a:extLst>
                                <a:ext uri="{FF2B5EF4-FFF2-40B4-BE49-F238E27FC236}">
                                  <a16:creationId xmlns:a16="http://schemas.microsoft.com/office/drawing/2014/main" id="{C7C255FA-1B8D-49BE-8852-7F40C0A9D659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478833" y="2207991"/>
                              <a:ext cx="925020" cy="384721"/>
                              <a:chOff x="4468497" y="1465076"/>
                              <a:chExt cx="925020" cy="384721"/>
                            </a:xfrm>
                          </p:grpSpPr>
                          <p:sp>
                            <p:nvSpPr>
                              <p:cNvPr id="122" name="文本框 121">
                                <a:extLst>
                                  <a:ext uri="{FF2B5EF4-FFF2-40B4-BE49-F238E27FC236}">
                                    <a16:creationId xmlns:a16="http://schemas.microsoft.com/office/drawing/2014/main" id="{E2D86424-F560-4DB0-B4E2-55512EC64E48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468497" y="1465076"/>
                                <a:ext cx="645269" cy="384721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CDP-ME</a:t>
                                </a:r>
                                <a:endParaRPr lang="zh-CN" altLang="en-US" sz="9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  <a:p>
                                <a:endParaRPr lang="zh-CN" altLang="en-US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23" name="矩形 122">
                                <a:extLst>
                                  <a:ext uri="{FF2B5EF4-FFF2-40B4-BE49-F238E27FC236}">
                                    <a16:creationId xmlns:a16="http://schemas.microsoft.com/office/drawing/2014/main" id="{32FB6E8B-E00F-4D05-8394-5F43A8B0C8FA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4989509" y="1658362"/>
                                <a:ext cx="404008" cy="164055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solidFill>
                                  <a:srgbClr val="FF0000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altLang="zh-CN" sz="700" b="1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CMK</a:t>
                                </a:r>
                                <a:endParaRPr lang="zh-CN" altLang="en-US" sz="7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24" name="直接箭头连接符 123">
                                <a:extLst>
                                  <a:ext uri="{FF2B5EF4-FFF2-40B4-BE49-F238E27FC236}">
                                    <a16:creationId xmlns:a16="http://schemas.microsoft.com/office/drawing/2014/main" id="{A6696582-AAC4-441F-8E9B-372A26FC6BF2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21540000">
                                <a:off x="4751709" y="1661965"/>
                                <a:ext cx="0" cy="180928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125" name="组合 124">
                              <a:extLst>
                                <a:ext uri="{FF2B5EF4-FFF2-40B4-BE49-F238E27FC236}">
                                  <a16:creationId xmlns:a16="http://schemas.microsoft.com/office/drawing/2014/main" id="{024F30F9-04AE-4F2B-9826-2895BA240289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453099" y="2546706"/>
                              <a:ext cx="1072458" cy="374593"/>
                              <a:chOff x="4448066" y="1468300"/>
                              <a:chExt cx="1072458" cy="374593"/>
                            </a:xfrm>
                          </p:grpSpPr>
                          <p:sp>
                            <p:nvSpPr>
                              <p:cNvPr id="126" name="文本框 125">
                                <a:extLst>
                                  <a:ext uri="{FF2B5EF4-FFF2-40B4-BE49-F238E27FC236}">
                                    <a16:creationId xmlns:a16="http://schemas.microsoft.com/office/drawing/2014/main" id="{F2823E6B-7CBA-4B41-8A5E-DBB69E9C50E6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448066" y="1468300"/>
                                <a:ext cx="727419" cy="23083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CDP-MEP</a:t>
                                </a:r>
                                <a:endParaRPr lang="zh-CN" altLang="en-US" sz="9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27" name="矩形 126">
                                <a:extLst>
                                  <a:ext uri="{FF2B5EF4-FFF2-40B4-BE49-F238E27FC236}">
                                    <a16:creationId xmlns:a16="http://schemas.microsoft.com/office/drawing/2014/main" id="{EA7D5694-BC72-420A-B71A-7D9175D56A2E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4990282" y="1671525"/>
                                <a:ext cx="530242" cy="161807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solidFill>
                                  <a:srgbClr val="FF0000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r>
                                  <a:rPr lang="en-US" altLang="zh-CN" sz="700" b="1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MECPS</a:t>
                                </a:r>
                                <a:endParaRPr lang="zh-CN" altLang="en-US" sz="7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28" name="直接箭头连接符 127">
                                <a:extLst>
                                  <a:ext uri="{FF2B5EF4-FFF2-40B4-BE49-F238E27FC236}">
                                    <a16:creationId xmlns:a16="http://schemas.microsoft.com/office/drawing/2014/main" id="{E71D4376-9050-4725-B17E-07F665D646C3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21540000">
                                <a:off x="4751709" y="1661965"/>
                                <a:ext cx="0" cy="180928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129" name="组合 128">
                              <a:extLst>
                                <a:ext uri="{FF2B5EF4-FFF2-40B4-BE49-F238E27FC236}">
                                  <a16:creationId xmlns:a16="http://schemas.microsoft.com/office/drawing/2014/main" id="{D50ACB6A-1F76-442D-A03C-467125BC60D6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478080" y="2914227"/>
                              <a:ext cx="645269" cy="377817"/>
                              <a:chOff x="4468497" y="1465076"/>
                              <a:chExt cx="645269" cy="377817"/>
                            </a:xfrm>
                          </p:grpSpPr>
                          <p:sp>
                            <p:nvSpPr>
                              <p:cNvPr id="130" name="文本框 129">
                                <a:extLst>
                                  <a:ext uri="{FF2B5EF4-FFF2-40B4-BE49-F238E27FC236}">
                                    <a16:creationId xmlns:a16="http://schemas.microsoft.com/office/drawing/2014/main" id="{6BBE0CB8-3711-4A70-9F73-CCA1C5342F25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468497" y="1465076"/>
                                <a:ext cx="645269" cy="23083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ME-cPP</a:t>
                                </a:r>
                                <a:endParaRPr lang="zh-CN" altLang="en-US" sz="9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32" name="直接箭头连接符 131">
                                <a:extLst>
                                  <a:ext uri="{FF2B5EF4-FFF2-40B4-BE49-F238E27FC236}">
                                    <a16:creationId xmlns:a16="http://schemas.microsoft.com/office/drawing/2014/main" id="{45C0A49B-9684-4DFC-B938-C1DF26A3AF28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21540000">
                                <a:off x="4751709" y="1661965"/>
                                <a:ext cx="0" cy="180928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133" name="组合 132">
                              <a:extLst>
                                <a:ext uri="{FF2B5EF4-FFF2-40B4-BE49-F238E27FC236}">
                                  <a16:creationId xmlns:a16="http://schemas.microsoft.com/office/drawing/2014/main" id="{DECC5C58-23AA-4F4E-975D-535B59E68F6F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482470" y="3259631"/>
                              <a:ext cx="645269" cy="377817"/>
                              <a:chOff x="4468497" y="1465076"/>
                              <a:chExt cx="645269" cy="377817"/>
                            </a:xfrm>
                          </p:grpSpPr>
                          <p:sp>
                            <p:nvSpPr>
                              <p:cNvPr id="134" name="文本框 133">
                                <a:extLst>
                                  <a:ext uri="{FF2B5EF4-FFF2-40B4-BE49-F238E27FC236}">
                                    <a16:creationId xmlns:a16="http://schemas.microsoft.com/office/drawing/2014/main" id="{E6A915D5-0628-4602-BE5D-5C1DE9F7568A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468497" y="1465076"/>
                                <a:ext cx="645269" cy="23083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HMBPP</a:t>
                                </a:r>
                                <a:endParaRPr lang="zh-CN" altLang="en-US" sz="9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36" name="直接箭头连接符 135">
                                <a:extLst>
                                  <a:ext uri="{FF2B5EF4-FFF2-40B4-BE49-F238E27FC236}">
                                    <a16:creationId xmlns:a16="http://schemas.microsoft.com/office/drawing/2014/main" id="{14BFD8F1-E3B9-4032-9A6B-B5FAEB94231A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21540000">
                                <a:off x="4751709" y="1661965"/>
                                <a:ext cx="0" cy="180928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142" name="矩形 141">
                              <a:extLst>
                                <a:ext uri="{FF2B5EF4-FFF2-40B4-BE49-F238E27FC236}">
                                  <a16:creationId xmlns:a16="http://schemas.microsoft.com/office/drawing/2014/main" id="{A693A048-4731-4E82-AC93-F849A8762A8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990109" y="3077014"/>
                              <a:ext cx="404008" cy="164055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solidFill>
                                <a:srgbClr val="FF0000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8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HDS</a:t>
                              </a:r>
                              <a:endParaRPr lang="zh-CN" altLang="en-US" sz="800" b="1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43" name="矩形 142">
                            <a:extLst>
                              <a:ext uri="{FF2B5EF4-FFF2-40B4-BE49-F238E27FC236}">
                                <a16:creationId xmlns:a16="http://schemas.microsoft.com/office/drawing/2014/main" id="{08C34E7C-55F1-4DAF-847B-2EC78970740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983150" y="3452303"/>
                            <a:ext cx="425307" cy="154423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800" b="1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HDR</a:t>
                            </a:r>
                            <a:endParaRPr lang="zh-CN" altLang="en-US" sz="800" b="1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304" name="组合 303">
                          <a:extLst>
                            <a:ext uri="{FF2B5EF4-FFF2-40B4-BE49-F238E27FC236}">
                              <a16:creationId xmlns:a16="http://schemas.microsoft.com/office/drawing/2014/main" id="{1E288D02-C378-4EE5-89C8-5F957D47996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381949" y="3802422"/>
                          <a:ext cx="1012168" cy="1633196"/>
                          <a:chOff x="4381949" y="3802422"/>
                          <a:chExt cx="1012168" cy="1633196"/>
                        </a:xfrm>
                      </p:grpSpPr>
                      <p:sp>
                        <p:nvSpPr>
                          <p:cNvPr id="116" name="文本框 115">
                            <a:extLst>
                              <a:ext uri="{FF2B5EF4-FFF2-40B4-BE49-F238E27FC236}">
                                <a16:creationId xmlns:a16="http://schemas.microsoft.com/office/drawing/2014/main" id="{17B592DE-16E1-499E-A1E5-48EF53140C5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381949" y="5038156"/>
                            <a:ext cx="95480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altLang="zh-CN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carotenoids</a:t>
                            </a:r>
                            <a:endParaRPr lang="zh-CN" altLang="en-US" sz="14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grpSp>
                        <p:nvGrpSpPr>
                          <p:cNvPr id="146" name="组合 145">
                            <a:extLst>
                              <a:ext uri="{FF2B5EF4-FFF2-40B4-BE49-F238E27FC236}">
                                <a16:creationId xmlns:a16="http://schemas.microsoft.com/office/drawing/2014/main" id="{328EFF9B-8DA0-4D7A-BE2E-FFA0CAE54B36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554416" y="3802422"/>
                            <a:ext cx="834170" cy="516768"/>
                            <a:chOff x="4545238" y="1326125"/>
                            <a:chExt cx="834170" cy="516768"/>
                          </a:xfrm>
                        </p:grpSpPr>
                        <p:sp>
                          <p:nvSpPr>
                            <p:cNvPr id="147" name="文本框 146">
                              <a:extLst>
                                <a:ext uri="{FF2B5EF4-FFF2-40B4-BE49-F238E27FC236}">
                                  <a16:creationId xmlns:a16="http://schemas.microsoft.com/office/drawing/2014/main" id="{6BBAC428-309E-4392-AF08-580965EFD05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545238" y="1456900"/>
                              <a:ext cx="569686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GPP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48" name="矩形 147">
                              <a:extLst>
                                <a:ext uri="{FF2B5EF4-FFF2-40B4-BE49-F238E27FC236}">
                                  <a16:creationId xmlns:a16="http://schemas.microsoft.com/office/drawing/2014/main" id="{33F0A70C-702E-4030-8517-9239803347C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975400" y="1326125"/>
                              <a:ext cx="404008" cy="164055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solidFill>
                                <a:srgbClr val="FF0000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8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GPS</a:t>
                              </a:r>
                              <a:endParaRPr lang="zh-CN" altLang="en-US" sz="800" b="1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149" name="直接箭头连接符 148">
                              <a:extLst>
                                <a:ext uri="{FF2B5EF4-FFF2-40B4-BE49-F238E27FC236}">
                                  <a16:creationId xmlns:a16="http://schemas.microsoft.com/office/drawing/2014/main" id="{9C742239-A4A3-4B6D-8EAB-C2D9A639EEF2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rot="21540000">
                              <a:off x="4751709" y="1661965"/>
                              <a:ext cx="0" cy="180928"/>
                            </a:xfrm>
                            <a:prstGeom prst="straightConnector1">
                              <a:avLst/>
                            </a:prstGeom>
                            <a:ln w="19050">
                              <a:solidFill>
                                <a:schemeClr val="tx1"/>
                              </a:solidFill>
                              <a:tailEnd type="triangle"/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grpSp>
                        <p:nvGrpSpPr>
                          <p:cNvPr id="155" name="组合 154">
                            <a:extLst>
                              <a:ext uri="{FF2B5EF4-FFF2-40B4-BE49-F238E27FC236}">
                                <a16:creationId xmlns:a16="http://schemas.microsoft.com/office/drawing/2014/main" id="{C2AB6DA7-CF8C-4A8B-87B9-8B04A120E931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497188" y="4509309"/>
                            <a:ext cx="896929" cy="410276"/>
                            <a:chOff x="4502480" y="1292546"/>
                            <a:chExt cx="896929" cy="410276"/>
                          </a:xfrm>
                        </p:grpSpPr>
                        <p:sp>
                          <p:nvSpPr>
                            <p:cNvPr id="156" name="文本框 155">
                              <a:extLst>
                                <a:ext uri="{FF2B5EF4-FFF2-40B4-BE49-F238E27FC236}">
                                  <a16:creationId xmlns:a16="http://schemas.microsoft.com/office/drawing/2014/main" id="{F9B63BE0-27F2-4BFF-BB62-EF7F5F2EF5D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502480" y="1456601"/>
                              <a:ext cx="569686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0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GGPP</a:t>
                              </a:r>
                              <a:endParaRPr lang="zh-CN" altLang="en-US" sz="100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57" name="矩形 156">
                              <a:extLst>
                                <a:ext uri="{FF2B5EF4-FFF2-40B4-BE49-F238E27FC236}">
                                  <a16:creationId xmlns:a16="http://schemas.microsoft.com/office/drawing/2014/main" id="{B7ED2875-BBB8-445C-BB84-19376D26541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995401" y="1292546"/>
                              <a:ext cx="404008" cy="164055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solidFill>
                                <a:srgbClr val="FF0000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800" b="1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FPS</a:t>
                              </a:r>
                              <a:endParaRPr lang="zh-CN" altLang="en-US" sz="800" b="1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208" name="直接箭头连接符 207">
                            <a:extLst>
                              <a:ext uri="{FF2B5EF4-FFF2-40B4-BE49-F238E27FC236}">
                                <a16:creationId xmlns:a16="http://schemas.microsoft.com/office/drawing/2014/main" id="{FA57A075-00B9-43FB-A648-39276CFED45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4782031" y="4863926"/>
                            <a:ext cx="0" cy="201055"/>
                          </a:xfrm>
                          <a:prstGeom prst="straightConnector1">
                            <a:avLst/>
                          </a:prstGeom>
                          <a:ln w="19050">
                            <a:prstDash val="sysDash"/>
                            <a:tailEnd type="triangle"/>
                          </a:ln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20" name="直接箭头连接符 219">
                            <a:extLst>
                              <a:ext uri="{FF2B5EF4-FFF2-40B4-BE49-F238E27FC236}">
                                <a16:creationId xmlns:a16="http://schemas.microsoft.com/office/drawing/2014/main" id="{D7AB2E55-E56C-4AB6-9D93-F93971D3AB2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1540000">
                            <a:off x="4767218" y="5254690"/>
                            <a:ext cx="0" cy="180928"/>
                          </a:xfrm>
                          <a:prstGeom prst="straightConnector1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310" name="组合 309">
                          <a:extLst>
                            <a:ext uri="{FF2B5EF4-FFF2-40B4-BE49-F238E27FC236}">
                              <a16:creationId xmlns:a16="http://schemas.microsoft.com/office/drawing/2014/main" id="{49FB4056-CD6E-4836-A38C-65FCE833358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261307" y="5686018"/>
                          <a:ext cx="3280805" cy="2107883"/>
                          <a:chOff x="3261219" y="5777425"/>
                          <a:chExt cx="3280805" cy="2107883"/>
                        </a:xfrm>
                      </p:grpSpPr>
                      <p:grpSp>
                        <p:nvGrpSpPr>
                          <p:cNvPr id="307" name="组合 306">
                            <a:extLst>
                              <a:ext uri="{FF2B5EF4-FFF2-40B4-BE49-F238E27FC236}">
                                <a16:creationId xmlns:a16="http://schemas.microsoft.com/office/drawing/2014/main" id="{44FE95C3-5572-4CF6-B806-1E92E9F94F9A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261219" y="5900536"/>
                            <a:ext cx="1130357" cy="912659"/>
                            <a:chOff x="3261219" y="5900536"/>
                            <a:chExt cx="1130357" cy="912659"/>
                          </a:xfrm>
                        </p:grpSpPr>
                        <p:cxnSp>
                          <p:nvCxnSpPr>
                            <p:cNvPr id="262" name="直接箭头连接符 261">
                              <a:extLst>
                                <a:ext uri="{FF2B5EF4-FFF2-40B4-BE49-F238E27FC236}">
                                  <a16:creationId xmlns:a16="http://schemas.microsoft.com/office/drawing/2014/main" id="{72DCC99D-C29A-453E-9874-602F93E5A851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3802101" y="6498917"/>
                              <a:ext cx="589475" cy="314278"/>
                            </a:xfrm>
                            <a:prstGeom prst="straightConnector1">
                              <a:avLst/>
                            </a:prstGeom>
                            <a:ln w="19050">
                              <a:tailEnd type="triangle"/>
                            </a:ln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grpSp>
                          <p:nvGrpSpPr>
                            <p:cNvPr id="306" name="组合 305">
                              <a:extLst>
                                <a:ext uri="{FF2B5EF4-FFF2-40B4-BE49-F238E27FC236}">
                                  <a16:creationId xmlns:a16="http://schemas.microsoft.com/office/drawing/2014/main" id="{628FCBBC-1092-4772-BD99-B6502D829EF4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261219" y="5900536"/>
                              <a:ext cx="1108253" cy="737903"/>
                              <a:chOff x="3261219" y="5900536"/>
                              <a:chExt cx="1108253" cy="737903"/>
                            </a:xfrm>
                          </p:grpSpPr>
                          <p:grpSp>
                            <p:nvGrpSpPr>
                              <p:cNvPr id="284" name="组合 283">
                                <a:extLst>
                                  <a:ext uri="{FF2B5EF4-FFF2-40B4-BE49-F238E27FC236}">
                                    <a16:creationId xmlns:a16="http://schemas.microsoft.com/office/drawing/2014/main" id="{83B94621-F644-43FF-B464-E7626D7BD7A5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3261219" y="5900536"/>
                                <a:ext cx="1080719" cy="546665"/>
                                <a:chOff x="3261219" y="5900536"/>
                                <a:chExt cx="1080719" cy="546665"/>
                              </a:xfrm>
                            </p:grpSpPr>
                            <p:sp>
                              <p:nvSpPr>
                                <p:cNvPr id="237" name="文本框 236">
                                  <a:extLst>
                                    <a:ext uri="{FF2B5EF4-FFF2-40B4-BE49-F238E27FC236}">
                                      <a16:creationId xmlns:a16="http://schemas.microsoft.com/office/drawing/2014/main" id="{13DDC66D-56FB-4973-8B6A-55F904E0C99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261219" y="6216369"/>
                                  <a:ext cx="1042903" cy="230832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9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9-cis-violaxanthin</a:t>
                                  </a:r>
                                  <a:endParaRPr lang="zh-CN" altLang="en-US" sz="16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cxnSp>
                              <p:nvCxnSpPr>
                                <p:cNvPr id="240" name="直接箭头连接符 239">
                                  <a:extLst>
                                    <a:ext uri="{FF2B5EF4-FFF2-40B4-BE49-F238E27FC236}">
                                      <a16:creationId xmlns:a16="http://schemas.microsoft.com/office/drawing/2014/main" id="{9482CC43-A96C-4CB7-9924-9BEAF64922D2}"/>
                                    </a:ext>
                                  </a:extLst>
                                </p:cNvPr>
                                <p:cNvCxnSpPr>
                                  <a:cxnSpLocks/>
                                  <a:stCxn id="228" idx="1"/>
                                  <a:endCxn id="237" idx="0"/>
                                </p:cNvCxnSpPr>
                                <p:nvPr/>
                              </p:nvCxnSpPr>
                              <p:spPr>
                                <a:xfrm flipH="1">
                                  <a:off x="3782671" y="5900536"/>
                                  <a:ext cx="559267" cy="315833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dk1"/>
                                </a:lnRef>
                                <a:fillRef idx="0">
                                  <a:schemeClr val="dk1"/>
                                </a:fillRef>
                                <a:effectRef idx="0">
                                  <a:schemeClr val="dk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sp>
                            <p:nvSpPr>
                              <p:cNvPr id="271" name="矩形 270">
                                <a:extLst>
                                  <a:ext uri="{FF2B5EF4-FFF2-40B4-BE49-F238E27FC236}">
                                    <a16:creationId xmlns:a16="http://schemas.microsoft.com/office/drawing/2014/main" id="{1D36B4F9-4AC7-4288-B581-E181B9B8F9C9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 rot="1693268">
                                <a:off x="3948246" y="6512593"/>
                                <a:ext cx="421226" cy="125846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altLang="zh-CN" sz="600" b="1">
                                    <a:solidFill>
                                      <a:schemeClr val="tx1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NCED</a:t>
                                </a:r>
                                <a:endParaRPr lang="zh-CN" altLang="en-US" sz="600" b="1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</p:grpSp>
                      </p:grpSp>
                      <p:grpSp>
                        <p:nvGrpSpPr>
                          <p:cNvPr id="309" name="组合 308">
                            <a:extLst>
                              <a:ext uri="{FF2B5EF4-FFF2-40B4-BE49-F238E27FC236}">
                                <a16:creationId xmlns:a16="http://schemas.microsoft.com/office/drawing/2014/main" id="{FFE51788-B084-4972-B7F9-6841B9478B5F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145667" y="5777425"/>
                            <a:ext cx="2396357" cy="2107883"/>
                            <a:chOff x="4145667" y="5777425"/>
                            <a:chExt cx="2396357" cy="2107883"/>
                          </a:xfrm>
                        </p:grpSpPr>
                        <p:grpSp>
                          <p:nvGrpSpPr>
                            <p:cNvPr id="285" name="组合 284">
                              <a:extLst>
                                <a:ext uri="{FF2B5EF4-FFF2-40B4-BE49-F238E27FC236}">
                                  <a16:creationId xmlns:a16="http://schemas.microsoft.com/office/drawing/2014/main" id="{20503300-0DFE-4CA5-8CA5-56E869355988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5325163" y="7165021"/>
                              <a:ext cx="1216861" cy="414462"/>
                              <a:chOff x="3063334" y="6001517"/>
                              <a:chExt cx="1400361" cy="455015"/>
                            </a:xfrm>
                          </p:grpSpPr>
                          <p:sp>
                            <p:nvSpPr>
                              <p:cNvPr id="286" name="文本框 285">
                                <a:extLst>
                                  <a:ext uri="{FF2B5EF4-FFF2-40B4-BE49-F238E27FC236}">
                                    <a16:creationId xmlns:a16="http://schemas.microsoft.com/office/drawing/2014/main" id="{0B2EDB47-CF7D-4CE1-B2A7-5DCA4B5EF1CE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063334" y="6203114"/>
                                <a:ext cx="1400361" cy="253418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altLang="zh-CN" sz="9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     abscisic alcohol</a:t>
                                </a:r>
                                <a:endParaRPr lang="zh-CN" altLang="en-US" sz="160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287" name="直接箭头连接符 286">
                                <a:extLst>
                                  <a:ext uri="{FF2B5EF4-FFF2-40B4-BE49-F238E27FC236}">
                                    <a16:creationId xmlns:a16="http://schemas.microsoft.com/office/drawing/2014/main" id="{27D9FD43-E4C3-463C-B25E-E963575DD94E}"/>
                                  </a:ext>
                                </a:extLst>
                              </p:cNvPr>
                              <p:cNvCxnSpPr>
                                <a:cxnSpLocks/>
                                <a:endCxn id="286" idx="0"/>
                              </p:cNvCxnSpPr>
                              <p:nvPr/>
                            </p:nvCxnSpPr>
                            <p:spPr>
                              <a:xfrm>
                                <a:off x="3172699" y="6001517"/>
                                <a:ext cx="590818" cy="201596"/>
                              </a:xfrm>
                              <a:prstGeom prst="straightConnector1">
                                <a:avLst/>
                              </a:prstGeom>
                              <a:ln w="19050">
                                <a:prstDash val="dash"/>
                                <a:tailEnd type="triangle"/>
                              </a:ln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308" name="组合 307">
                              <a:extLst>
                                <a:ext uri="{FF2B5EF4-FFF2-40B4-BE49-F238E27FC236}">
                                  <a16:creationId xmlns:a16="http://schemas.microsoft.com/office/drawing/2014/main" id="{B329D104-3F94-4ED5-A5E9-623DCBBF4F2A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145667" y="5777425"/>
                              <a:ext cx="1794207" cy="2107883"/>
                              <a:chOff x="4145667" y="5777425"/>
                              <a:chExt cx="1794207" cy="2107883"/>
                            </a:xfrm>
                          </p:grpSpPr>
                          <p:grpSp>
                            <p:nvGrpSpPr>
                              <p:cNvPr id="232" name="组合 231">
                                <a:extLst>
                                  <a:ext uri="{FF2B5EF4-FFF2-40B4-BE49-F238E27FC236}">
                                    <a16:creationId xmlns:a16="http://schemas.microsoft.com/office/drawing/2014/main" id="{D73C6528-FA77-4721-ABA2-44C97295951B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4368571" y="6093259"/>
                                <a:ext cx="954802" cy="405671"/>
                                <a:chOff x="4375051" y="5423655"/>
                                <a:chExt cx="954802" cy="405671"/>
                              </a:xfrm>
                            </p:grpSpPr>
                            <p:sp>
                              <p:nvSpPr>
                                <p:cNvPr id="233" name="文本框 232">
                                  <a:extLst>
                                    <a:ext uri="{FF2B5EF4-FFF2-40B4-BE49-F238E27FC236}">
                                      <a16:creationId xmlns:a16="http://schemas.microsoft.com/office/drawing/2014/main" id="{9FC9529B-D3A4-4BE8-96D0-2FAD42319069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375051" y="5423655"/>
                                  <a:ext cx="954802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10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neoxanthin</a:t>
                                  </a:r>
                                  <a:endParaRPr lang="zh-CN" altLang="en-US" sz="105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cxnSp>
                              <p:nvCxnSpPr>
                                <p:cNvPr id="236" name="直接箭头连接符 235">
                                  <a:extLst>
                                    <a:ext uri="{FF2B5EF4-FFF2-40B4-BE49-F238E27FC236}">
                                      <a16:creationId xmlns:a16="http://schemas.microsoft.com/office/drawing/2014/main" id="{34D0B794-B8FE-4C0E-A49B-530AD731FCAC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21540000">
                                  <a:off x="4769175" y="5648398"/>
                                  <a:ext cx="0" cy="180928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grpSp>
                            <p:nvGrpSpPr>
                              <p:cNvPr id="272" name="组合 271">
                                <a:extLst>
                                  <a:ext uri="{FF2B5EF4-FFF2-40B4-BE49-F238E27FC236}">
                                    <a16:creationId xmlns:a16="http://schemas.microsoft.com/office/drawing/2014/main" id="{07AC928A-DDC9-4497-A03D-3F8AB075A608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4304630" y="6591331"/>
                                <a:ext cx="1069709" cy="344975"/>
                                <a:chOff x="4304630" y="6591331"/>
                                <a:chExt cx="1069709" cy="344975"/>
                              </a:xfrm>
                            </p:grpSpPr>
                            <p:sp>
                              <p:nvSpPr>
                                <p:cNvPr id="247" name="文本框 246">
                                  <a:extLst>
                                    <a:ext uri="{FF2B5EF4-FFF2-40B4-BE49-F238E27FC236}">
                                      <a16:creationId xmlns:a16="http://schemas.microsoft.com/office/drawing/2014/main" id="{E88CFA90-2EA8-4DA8-8EE9-EA0CE0930E0E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304630" y="6690085"/>
                                  <a:ext cx="954802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10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   xanthoxin</a:t>
                                  </a:r>
                                  <a:endParaRPr lang="zh-CN" altLang="en-US" sz="105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cxnSp>
                              <p:nvCxnSpPr>
                                <p:cNvPr id="261" name="直接箭头连接符 260">
                                  <a:extLst>
                                    <a:ext uri="{FF2B5EF4-FFF2-40B4-BE49-F238E27FC236}">
                                      <a16:creationId xmlns:a16="http://schemas.microsoft.com/office/drawing/2014/main" id="{D8F0BBE3-2B95-4FEB-993F-1DBAAC29B729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21540000">
                                  <a:off x="4765204" y="6591331"/>
                                  <a:ext cx="0" cy="180928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sp>
                              <p:nvSpPr>
                                <p:cNvPr id="270" name="矩形 269">
                                  <a:extLst>
                                    <a:ext uri="{FF2B5EF4-FFF2-40B4-BE49-F238E27FC236}">
                                      <a16:creationId xmlns:a16="http://schemas.microsoft.com/office/drawing/2014/main" id="{A158CCC5-C685-4375-B0B1-BCE09F98875F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4970331" y="6600051"/>
                                  <a:ext cx="404008" cy="99053"/>
                                </a:xfrm>
                                <a:prstGeom prst="rect">
                                  <a:avLst/>
                                </a:prstGeom>
                                <a:noFill/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altLang="zh-CN" sz="600" b="1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NCED</a:t>
                                  </a:r>
                                  <a:endParaRPr lang="zh-CN" altLang="en-US" sz="600" b="1">
                                    <a:solidFill>
                                      <a:schemeClr val="tx1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</p:grpSp>
                          <p:grpSp>
                            <p:nvGrpSpPr>
                              <p:cNvPr id="305" name="组合 304">
                                <a:extLst>
                                  <a:ext uri="{FF2B5EF4-FFF2-40B4-BE49-F238E27FC236}">
                                    <a16:creationId xmlns:a16="http://schemas.microsoft.com/office/drawing/2014/main" id="{14DDFE79-87D7-49E2-BFC4-9D37AD930768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4145667" y="5777425"/>
                                <a:ext cx="1794207" cy="2107883"/>
                                <a:chOff x="4145667" y="5777425"/>
                                <a:chExt cx="1794207" cy="2107883"/>
                              </a:xfrm>
                            </p:grpSpPr>
                            <p:grpSp>
                              <p:nvGrpSpPr>
                                <p:cNvPr id="227" name="组合 226">
                                  <a:extLst>
                                    <a:ext uri="{FF2B5EF4-FFF2-40B4-BE49-F238E27FC236}">
                                      <a16:creationId xmlns:a16="http://schemas.microsoft.com/office/drawing/2014/main" id="{FBCFC743-EB1C-40EC-986C-4981B445FD94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4341938" y="5777425"/>
                                  <a:ext cx="1001259" cy="399482"/>
                                  <a:chOff x="4335368" y="5475564"/>
                                  <a:chExt cx="1001259" cy="399482"/>
                                </a:xfrm>
                              </p:grpSpPr>
                              <p:sp>
                                <p:nvSpPr>
                                  <p:cNvPr id="228" name="文本框 227">
                                    <a:extLst>
                                      <a:ext uri="{FF2B5EF4-FFF2-40B4-BE49-F238E27FC236}">
                                        <a16:creationId xmlns:a16="http://schemas.microsoft.com/office/drawing/2014/main" id="{BF2B4281-D31E-4E0D-91A3-C1BC5D4E01B0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335368" y="5475564"/>
                                    <a:ext cx="954802" cy="24622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en-US" altLang="zh-CN" sz="1000"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violaxanthin</a:t>
                                    </a:r>
                                    <a:endParaRPr lang="zh-CN" altLang="en-US" sz="14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  <p:grpSp>
                                <p:nvGrpSpPr>
                                  <p:cNvPr id="229" name="组合 228">
                                    <a:extLst>
                                      <a:ext uri="{FF2B5EF4-FFF2-40B4-BE49-F238E27FC236}">
                                        <a16:creationId xmlns:a16="http://schemas.microsoft.com/office/drawing/2014/main" id="{B9CAA81A-95BD-46E9-95AF-15B333C833D1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4761555" y="5694118"/>
                                    <a:ext cx="575072" cy="180928"/>
                                    <a:chOff x="4736469" y="1627675"/>
                                    <a:chExt cx="575072" cy="180928"/>
                                  </a:xfrm>
                                </p:grpSpPr>
                                <p:sp>
                                  <p:nvSpPr>
                                    <p:cNvPr id="230" name="矩形 229">
                                      <a:extLst>
                                        <a:ext uri="{FF2B5EF4-FFF2-40B4-BE49-F238E27FC236}">
                                          <a16:creationId xmlns:a16="http://schemas.microsoft.com/office/drawing/2014/main" id="{67C8144B-5765-4896-B2D8-30804500350E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4943718" y="1636227"/>
                                      <a:ext cx="367823" cy="150733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pPr algn="ctr"/>
                                      <a:r>
                                        <a:rPr lang="en-US" altLang="zh-CN" sz="700" b="1">
                                          <a:solidFill>
                                            <a:schemeClr val="tx1"/>
                                          </a:solidFill>
                                          <a:latin typeface="Times New Roman" panose="02020603050405020304" pitchFamily="18" charset="0"/>
                                          <a:cs typeface="Times New Roman" panose="02020603050405020304" pitchFamily="18" charset="0"/>
                                        </a:rPr>
                                        <a:t>NSY</a:t>
                                      </a:r>
                                      <a:endParaRPr lang="zh-CN" altLang="en-US" sz="700" b="1">
                                        <a:solidFill>
                                          <a:schemeClr val="tx1"/>
                                        </a:solidFill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</p:txBody>
                                </p:sp>
                                <p:cxnSp>
                                  <p:nvCxnSpPr>
                                    <p:cNvPr id="231" name="直接箭头连接符 230">
                                      <a:extLst>
                                        <a:ext uri="{FF2B5EF4-FFF2-40B4-BE49-F238E27FC236}">
                                          <a16:creationId xmlns:a16="http://schemas.microsoft.com/office/drawing/2014/main" id="{90F197F5-333B-42FE-B0F7-A9145024F6F7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</p:cNvCxnSpPr>
                                    <p:nvPr/>
                                  </p:nvCxnSpPr>
                                  <p:spPr>
                                    <a:xfrm rot="21540000">
                                      <a:off x="4736469" y="1627675"/>
                                      <a:ext cx="0" cy="180928"/>
                                    </a:xfrm>
                                    <a:prstGeom prst="straightConnector1">
                                      <a:avLst/>
                                    </a:prstGeom>
                                    <a:ln w="19050">
                                      <a:solidFill>
                                        <a:schemeClr val="tx1"/>
                                      </a:solidFill>
                                      <a:tailEnd type="triangle"/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</p:grpSp>
                            </p:grpSp>
                            <p:sp>
                              <p:nvSpPr>
                                <p:cNvPr id="238" name="文本框 237">
                                  <a:extLst>
                                    <a:ext uri="{FF2B5EF4-FFF2-40B4-BE49-F238E27FC236}">
                                      <a16:creationId xmlns:a16="http://schemas.microsoft.com/office/drawing/2014/main" id="{813DFFBD-B8CC-4FE1-BB40-A2DCD6A8E759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305634" y="6428338"/>
                                  <a:ext cx="954802" cy="230832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US" altLang="zh-CN" sz="90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9-cis-neoxanthin</a:t>
                                  </a:r>
                                  <a:endParaRPr lang="zh-CN" altLang="en-US" sz="100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grpSp>
                              <p:nvGrpSpPr>
                                <p:cNvPr id="273" name="组合 272">
                                  <a:extLst>
                                    <a:ext uri="{FF2B5EF4-FFF2-40B4-BE49-F238E27FC236}">
                                      <a16:creationId xmlns:a16="http://schemas.microsoft.com/office/drawing/2014/main" id="{67097B13-50A2-4138-9B58-E2A0A5F0368A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4145667" y="6890804"/>
                                  <a:ext cx="1305949" cy="366605"/>
                                  <a:chOff x="4145667" y="6591331"/>
                                  <a:chExt cx="1305949" cy="366605"/>
                                </a:xfrm>
                              </p:grpSpPr>
                              <p:sp>
                                <p:nvSpPr>
                                  <p:cNvPr id="274" name="文本框 273">
                                    <a:extLst>
                                      <a:ext uri="{FF2B5EF4-FFF2-40B4-BE49-F238E27FC236}">
                                        <a16:creationId xmlns:a16="http://schemas.microsoft.com/office/drawing/2014/main" id="{744302DE-6EF7-4CD1-B1EE-FE402E1BE29A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145667" y="6711715"/>
                                    <a:ext cx="1175080" cy="24622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en-US" altLang="zh-CN" sz="1000"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   abscisic aldehyde</a:t>
                                    </a:r>
                                    <a:endParaRPr lang="zh-CN" altLang="en-US" sz="105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275" name="直接箭头连接符 274">
                                    <a:extLst>
                                      <a:ext uri="{FF2B5EF4-FFF2-40B4-BE49-F238E27FC236}">
                                        <a16:creationId xmlns:a16="http://schemas.microsoft.com/office/drawing/2014/main" id="{8C471FE1-D129-44DB-B093-82EB05A187DA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 rot="21540000">
                                    <a:off x="4765204" y="6591331"/>
                                    <a:ext cx="0" cy="180928"/>
                                  </a:xfrm>
                                  <a:prstGeom prst="straightConnector1">
                                    <a:avLst/>
                                  </a:prstGeom>
                                  <a:ln w="19050">
                                    <a:solidFill>
                                      <a:schemeClr val="tx1"/>
                                    </a:solidFill>
                                    <a:tailEnd type="triangle"/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sp>
                                <p:nvSpPr>
                                  <p:cNvPr id="276" name="矩形 275">
                                    <a:extLst>
                                      <a:ext uri="{FF2B5EF4-FFF2-40B4-BE49-F238E27FC236}">
                                        <a16:creationId xmlns:a16="http://schemas.microsoft.com/office/drawing/2014/main" id="{434D1051-EC64-4EC0-BBE4-A1658693B5A7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4970330" y="6610249"/>
                                    <a:ext cx="481286" cy="10371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solidFill>
                                      <a:srgbClr val="FF0000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r>
                                      <a:rPr lang="en-US" altLang="zh-CN" sz="700" b="1">
                                        <a:solidFill>
                                          <a:srgbClr val="FF0000"/>
                                        </a:solidFill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XanDH</a:t>
                                    </a:r>
                                    <a:endParaRPr lang="zh-CN" altLang="en-US" sz="700" b="1">
                                      <a:solidFill>
                                        <a:srgbClr val="FF0000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</p:grpSp>
                            <p:grpSp>
                              <p:nvGrpSpPr>
                                <p:cNvPr id="277" name="组合 276">
                                  <a:extLst>
                                    <a:ext uri="{FF2B5EF4-FFF2-40B4-BE49-F238E27FC236}">
                                      <a16:creationId xmlns:a16="http://schemas.microsoft.com/office/drawing/2014/main" id="{EC54CB46-DB78-453C-9904-C16F417BF824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4444525" y="7257409"/>
                                  <a:ext cx="908463" cy="627899"/>
                                  <a:chOff x="4445665" y="6299226"/>
                                  <a:chExt cx="908463" cy="627899"/>
                                </a:xfrm>
                              </p:grpSpPr>
                              <p:sp>
                                <p:nvSpPr>
                                  <p:cNvPr id="278" name="文本框 277">
                                    <a:extLst>
                                      <a:ext uri="{FF2B5EF4-FFF2-40B4-BE49-F238E27FC236}">
                                        <a16:creationId xmlns:a16="http://schemas.microsoft.com/office/drawing/2014/main" id="{FC46F1E4-67F9-4E3D-A036-85B7D6B8589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445665" y="6680904"/>
                                    <a:ext cx="589475" cy="24622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en-US" altLang="zh-CN" sz="1000"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   ABA</a:t>
                                    </a:r>
                                    <a:endParaRPr lang="zh-CN" altLang="en-US" sz="105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279" name="直接箭头连接符 278">
                                    <a:extLst>
                                      <a:ext uri="{FF2B5EF4-FFF2-40B4-BE49-F238E27FC236}">
                                        <a16:creationId xmlns:a16="http://schemas.microsoft.com/office/drawing/2014/main" id="{049E8DCC-7F03-40BC-A338-3BC17841AA31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4759747" y="6299226"/>
                                    <a:ext cx="6144" cy="375024"/>
                                  </a:xfrm>
                                  <a:prstGeom prst="straightConnector1">
                                    <a:avLst/>
                                  </a:prstGeom>
                                  <a:ln w="19050">
                                    <a:solidFill>
                                      <a:schemeClr val="tx1"/>
                                    </a:solidFill>
                                    <a:tailEnd type="triangle"/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sp>
                                <p:nvSpPr>
                                  <p:cNvPr id="280" name="矩形 279">
                                    <a:extLst>
                                      <a:ext uri="{FF2B5EF4-FFF2-40B4-BE49-F238E27FC236}">
                                        <a16:creationId xmlns:a16="http://schemas.microsoft.com/office/drawing/2014/main" id="{6AE0110E-01E5-45EB-8FF5-974C5A95B578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4966722" y="6357903"/>
                                    <a:ext cx="387406" cy="13931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r>
                                      <a:rPr lang="en-US" altLang="zh-CN" sz="700" b="1">
                                        <a:solidFill>
                                          <a:schemeClr val="tx1"/>
                                        </a:solidFill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AAO</a:t>
                                    </a:r>
                                    <a:endParaRPr lang="zh-CN" altLang="en-US" sz="700" b="1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</p:grpSp>
                            <p:cxnSp>
                              <p:nvCxnSpPr>
                                <p:cNvPr id="291" name="直接箭头连接符 290">
                                  <a:extLst>
                                    <a:ext uri="{FF2B5EF4-FFF2-40B4-BE49-F238E27FC236}">
                                      <a16:creationId xmlns:a16="http://schemas.microsoft.com/office/drawing/2014/main" id="{286D3458-4E27-41A8-B780-8B68B9253B9D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flipH="1">
                                  <a:off x="5208367" y="7613685"/>
                                  <a:ext cx="731507" cy="159438"/>
                                </a:xfrm>
                                <a:prstGeom prst="straightConnector1">
                                  <a:avLst/>
                                </a:prstGeom>
                                <a:ln w="19050">
                                  <a:prstDash val="sysDash"/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dk1"/>
                                </a:lnRef>
                                <a:fillRef idx="0">
                                  <a:schemeClr val="dk1"/>
                                </a:fillRef>
                                <a:effectRef idx="0">
                                  <a:schemeClr val="dk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</p:grpSp>
                      </p:grpSp>
                    </p:grpSp>
                  </p:grpSp>
                  <p:grpSp>
                    <p:nvGrpSpPr>
                      <p:cNvPr id="318" name="组合 317">
                        <a:extLst>
                          <a:ext uri="{FF2B5EF4-FFF2-40B4-BE49-F238E27FC236}">
                            <a16:creationId xmlns:a16="http://schemas.microsoft.com/office/drawing/2014/main" id="{447BF64F-85AF-4C1A-B6ED-E64F548288B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78827" y="359870"/>
                        <a:ext cx="3167900" cy="6320970"/>
                        <a:chOff x="3178827" y="359870"/>
                        <a:chExt cx="3167900" cy="6320970"/>
                      </a:xfrm>
                    </p:grpSpPr>
                    <p:sp>
                      <p:nvSpPr>
                        <p:cNvPr id="313" name="矩形: 圆角 312">
                          <a:extLst>
                            <a:ext uri="{FF2B5EF4-FFF2-40B4-BE49-F238E27FC236}">
                              <a16:creationId xmlns:a16="http://schemas.microsoft.com/office/drawing/2014/main" id="{25504374-1D71-4ECC-B4B4-D4B95C7A5EC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39089" y="421419"/>
                          <a:ext cx="3047235" cy="6219707"/>
                        </a:xfrm>
                        <a:prstGeom prst="roundRect">
                          <a:avLst/>
                        </a:prstGeom>
                        <a:noFill/>
                        <a:ln w="19050">
                          <a:solidFill>
                            <a:schemeClr val="tx1">
                              <a:alpha val="69000"/>
                            </a:schemeClr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/>
                        </a:p>
                      </p:txBody>
                    </p:sp>
                    <p:sp>
                      <p:nvSpPr>
                        <p:cNvPr id="314" name="矩形: 圆角 313">
                          <a:extLst>
                            <a:ext uri="{FF2B5EF4-FFF2-40B4-BE49-F238E27FC236}">
                              <a16:creationId xmlns:a16="http://schemas.microsoft.com/office/drawing/2014/main" id="{1123FCCD-4E44-4F4B-8962-644AB677C11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78827" y="359870"/>
                          <a:ext cx="3167900" cy="6320970"/>
                        </a:xfrm>
                        <a:prstGeom prst="roundRect">
                          <a:avLst/>
                        </a:prstGeom>
                        <a:noFill/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/>
                        </a:p>
                      </p:txBody>
                    </p:sp>
                  </p:grpSp>
                </p:grpSp>
              </p:grpSp>
            </p:grpSp>
          </p:grpSp>
          <p:grpSp>
            <p:nvGrpSpPr>
              <p:cNvPr id="329" name="组合 328">
                <a:extLst>
                  <a:ext uri="{FF2B5EF4-FFF2-40B4-BE49-F238E27FC236}">
                    <a16:creationId xmlns:a16="http://schemas.microsoft.com/office/drawing/2014/main" id="{D4F9D2E3-9AC6-4D2B-968B-1A6B65535FF4}"/>
                  </a:ext>
                </a:extLst>
              </p:cNvPr>
              <p:cNvGrpSpPr/>
              <p:nvPr/>
            </p:nvGrpSpPr>
            <p:grpSpPr>
              <a:xfrm>
                <a:off x="5487026" y="1400899"/>
                <a:ext cx="195494" cy="5538261"/>
                <a:chOff x="5487026" y="1400899"/>
                <a:chExt cx="195494" cy="5538261"/>
              </a:xfrm>
            </p:grpSpPr>
            <p:grpSp>
              <p:nvGrpSpPr>
                <p:cNvPr id="328" name="组合 327">
                  <a:extLst>
                    <a:ext uri="{FF2B5EF4-FFF2-40B4-BE49-F238E27FC236}">
                      <a16:creationId xmlns:a16="http://schemas.microsoft.com/office/drawing/2014/main" id="{31CD203F-715E-4945-920D-22E6F5D1D8A0}"/>
                    </a:ext>
                  </a:extLst>
                </p:cNvPr>
                <p:cNvGrpSpPr/>
                <p:nvPr/>
              </p:nvGrpSpPr>
              <p:grpSpPr>
                <a:xfrm>
                  <a:off x="5487026" y="1400899"/>
                  <a:ext cx="195494" cy="2905441"/>
                  <a:chOff x="5487026" y="1400899"/>
                  <a:chExt cx="195494" cy="2905441"/>
                </a:xfrm>
              </p:grpSpPr>
              <p:sp>
                <p:nvSpPr>
                  <p:cNvPr id="322" name="星形: 五角 321">
                    <a:extLst>
                      <a:ext uri="{FF2B5EF4-FFF2-40B4-BE49-F238E27FC236}">
                        <a16:creationId xmlns:a16="http://schemas.microsoft.com/office/drawing/2014/main" id="{AA2D19CB-D58C-41CD-B272-C4E865CEA34F}"/>
                      </a:ext>
                    </a:extLst>
                  </p:cNvPr>
                  <p:cNvSpPr/>
                  <p:nvPr/>
                </p:nvSpPr>
                <p:spPr>
                  <a:xfrm>
                    <a:off x="5525557" y="1400899"/>
                    <a:ext cx="156963" cy="155229"/>
                  </a:xfrm>
                  <a:prstGeom prst="star5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3" name="星形: 五角 322">
                    <a:extLst>
                      <a:ext uri="{FF2B5EF4-FFF2-40B4-BE49-F238E27FC236}">
                        <a16:creationId xmlns:a16="http://schemas.microsoft.com/office/drawing/2014/main" id="{471BA436-BAEB-437F-B8D7-0F58D4612EA8}"/>
                      </a:ext>
                    </a:extLst>
                  </p:cNvPr>
                  <p:cNvSpPr/>
                  <p:nvPr/>
                </p:nvSpPr>
                <p:spPr>
                  <a:xfrm>
                    <a:off x="5487026" y="4151111"/>
                    <a:ext cx="156963" cy="155229"/>
                  </a:xfrm>
                  <a:prstGeom prst="star5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324" name="星形: 五角 323">
                  <a:extLst>
                    <a:ext uri="{FF2B5EF4-FFF2-40B4-BE49-F238E27FC236}">
                      <a16:creationId xmlns:a16="http://schemas.microsoft.com/office/drawing/2014/main" id="{4E682E0E-C404-4080-98B9-7DF838C686F3}"/>
                    </a:ext>
                  </a:extLst>
                </p:cNvPr>
                <p:cNvSpPr/>
                <p:nvPr/>
              </p:nvSpPr>
              <p:spPr>
                <a:xfrm>
                  <a:off x="5524382" y="6783931"/>
                  <a:ext cx="156963" cy="155229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327" name="组合 326">
                <a:extLst>
                  <a:ext uri="{FF2B5EF4-FFF2-40B4-BE49-F238E27FC236}">
                    <a16:creationId xmlns:a16="http://schemas.microsoft.com/office/drawing/2014/main" id="{C50FF317-581F-40D9-93B5-92123824E999}"/>
                  </a:ext>
                </a:extLst>
              </p:cNvPr>
              <p:cNvGrpSpPr/>
              <p:nvPr/>
            </p:nvGrpSpPr>
            <p:grpSpPr>
              <a:xfrm>
                <a:off x="2323226" y="472732"/>
                <a:ext cx="1830428" cy="4658354"/>
                <a:chOff x="2323226" y="472732"/>
                <a:chExt cx="1830428" cy="4658354"/>
              </a:xfrm>
            </p:grpSpPr>
            <p:sp>
              <p:nvSpPr>
                <p:cNvPr id="325" name="文本框 324">
                  <a:extLst>
                    <a:ext uri="{FF2B5EF4-FFF2-40B4-BE49-F238E27FC236}">
                      <a16:creationId xmlns:a16="http://schemas.microsoft.com/office/drawing/2014/main" id="{592C4DE9-86A9-4599-8D7B-B512BCA21893}"/>
                    </a:ext>
                  </a:extLst>
                </p:cNvPr>
                <p:cNvSpPr txBox="1"/>
                <p:nvPr/>
              </p:nvSpPr>
              <p:spPr>
                <a:xfrm>
                  <a:off x="2323226" y="472732"/>
                  <a:ext cx="85667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b="1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toplasm</a:t>
                  </a:r>
                  <a:endParaRPr lang="zh-CN" altLang="en-US" sz="1200" b="1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6" name="文本框 325">
                  <a:extLst>
                    <a:ext uri="{FF2B5EF4-FFF2-40B4-BE49-F238E27FC236}">
                      <a16:creationId xmlns:a16="http://schemas.microsoft.com/office/drawing/2014/main" id="{28818EF0-319B-4FD6-9708-325B12E56B92}"/>
                    </a:ext>
                  </a:extLst>
                </p:cNvPr>
                <p:cNvSpPr txBox="1"/>
                <p:nvPr/>
              </p:nvSpPr>
              <p:spPr>
                <a:xfrm>
                  <a:off x="3296982" y="4869476"/>
                  <a:ext cx="85667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b="1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stid</a:t>
                  </a:r>
                  <a:endParaRPr lang="zh-CN" altLang="en-US" sz="1200" b="1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088507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0</TotalTime>
  <Words>67</Words>
  <Application>Microsoft Office PowerPoint</Application>
  <PresentationFormat>A4 纸张(210x297 毫米)</PresentationFormat>
  <Paragraphs>5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li Yang</dc:creator>
  <cp:lastModifiedBy>Jiali Yang</cp:lastModifiedBy>
  <cp:revision>92</cp:revision>
  <dcterms:created xsi:type="dcterms:W3CDTF">2021-06-08T07:29:06Z</dcterms:created>
  <dcterms:modified xsi:type="dcterms:W3CDTF">2021-08-26T01:39:53Z</dcterms:modified>
</cp:coreProperties>
</file>